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7" r:id="rId2"/>
    <p:sldId id="258" r:id="rId3"/>
    <p:sldId id="259" r:id="rId4"/>
    <p:sldId id="260" r:id="rId5"/>
    <p:sldId id="261" r:id="rId6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2478" y="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wfs-zentral.top.gwdg.de\uzmb-all$\_uzmb100\Personen\Anusha%20Sriraman\2016\RES\190816_Viability%20assays_nut_bmi1i_epz_pd033299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JSA_nut_pd0332991!$J$15</c:f>
              <c:strCache>
                <c:ptCount val="1"/>
                <c:pt idx="0">
                  <c:v>16µM</c:v>
                </c:pt>
              </c:strCache>
            </c:strRef>
          </c:tx>
          <c:cat>
            <c:strRef>
              <c:f>SJSA_nut_pd0332991!$K$14:$Q$14</c:f>
              <c:strCache>
                <c:ptCount val="7"/>
                <c:pt idx="0">
                  <c:v>water</c:v>
                </c:pt>
                <c:pt idx="1">
                  <c:v>1µM</c:v>
                </c:pt>
                <c:pt idx="2">
                  <c:v>2µM</c:v>
                </c:pt>
                <c:pt idx="3">
                  <c:v>4µM</c:v>
                </c:pt>
                <c:pt idx="4">
                  <c:v>8µM</c:v>
                </c:pt>
                <c:pt idx="5">
                  <c:v>16µM</c:v>
                </c:pt>
                <c:pt idx="6">
                  <c:v>32µM</c:v>
                </c:pt>
              </c:strCache>
            </c:strRef>
          </c:cat>
          <c:val>
            <c:numRef>
              <c:f>SJSA_nut_pd0332991!$K$15:$Q$15</c:f>
              <c:numCache>
                <c:formatCode>General</c:formatCode>
                <c:ptCount val="7"/>
                <c:pt idx="0">
                  <c:v>1.4819955723340369E-2</c:v>
                </c:pt>
                <c:pt idx="1">
                  <c:v>1.5765775929056265E-2</c:v>
                </c:pt>
                <c:pt idx="2">
                  <c:v>2.1042694576786071E-2</c:v>
                </c:pt>
                <c:pt idx="3">
                  <c:v>4.1505081527355235E-2</c:v>
                </c:pt>
                <c:pt idx="4">
                  <c:v>5.102104359707698E-2</c:v>
                </c:pt>
                <c:pt idx="5">
                  <c:v>3.2129006988059019E-3</c:v>
                </c:pt>
                <c:pt idx="6">
                  <c:v>5.1370311173042681E-3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JSA_nut_pd0332991!$J$16</c:f>
              <c:strCache>
                <c:ptCount val="1"/>
                <c:pt idx="0">
                  <c:v>8µM</c:v>
                </c:pt>
              </c:strCache>
            </c:strRef>
          </c:tx>
          <c:cat>
            <c:strRef>
              <c:f>SJSA_nut_pd0332991!$K$14:$Q$14</c:f>
              <c:strCache>
                <c:ptCount val="7"/>
                <c:pt idx="0">
                  <c:v>water</c:v>
                </c:pt>
                <c:pt idx="1">
                  <c:v>1µM</c:v>
                </c:pt>
                <c:pt idx="2">
                  <c:v>2µM</c:v>
                </c:pt>
                <c:pt idx="3">
                  <c:v>4µM</c:v>
                </c:pt>
                <c:pt idx="4">
                  <c:v>8µM</c:v>
                </c:pt>
                <c:pt idx="5">
                  <c:v>16µM</c:v>
                </c:pt>
                <c:pt idx="6">
                  <c:v>32µM</c:v>
                </c:pt>
              </c:strCache>
            </c:strRef>
          </c:cat>
          <c:val>
            <c:numRef>
              <c:f>SJSA_nut_pd0332991!$K$16:$Q$16</c:f>
              <c:numCache>
                <c:formatCode>General</c:formatCode>
                <c:ptCount val="7"/>
                <c:pt idx="0">
                  <c:v>0.15101626034603663</c:v>
                </c:pt>
                <c:pt idx="1">
                  <c:v>0.23473578855503402</c:v>
                </c:pt>
                <c:pt idx="2">
                  <c:v>0.29571411681782039</c:v>
                </c:pt>
                <c:pt idx="3">
                  <c:v>0.37698245449368384</c:v>
                </c:pt>
                <c:pt idx="4">
                  <c:v>0.34162520430348192</c:v>
                </c:pt>
                <c:pt idx="5">
                  <c:v>1.8447104012245124E-2</c:v>
                </c:pt>
                <c:pt idx="6">
                  <c:v>6.3355513779824249E-3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SJSA_nut_pd0332991!$J$17</c:f>
              <c:strCache>
                <c:ptCount val="1"/>
                <c:pt idx="0">
                  <c:v>4µM</c:v>
                </c:pt>
              </c:strCache>
            </c:strRef>
          </c:tx>
          <c:cat>
            <c:strRef>
              <c:f>SJSA_nut_pd0332991!$K$14:$Q$14</c:f>
              <c:strCache>
                <c:ptCount val="7"/>
                <c:pt idx="0">
                  <c:v>water</c:v>
                </c:pt>
                <c:pt idx="1">
                  <c:v>1µM</c:v>
                </c:pt>
                <c:pt idx="2">
                  <c:v>2µM</c:v>
                </c:pt>
                <c:pt idx="3">
                  <c:v>4µM</c:v>
                </c:pt>
                <c:pt idx="4">
                  <c:v>8µM</c:v>
                </c:pt>
                <c:pt idx="5">
                  <c:v>16µM</c:v>
                </c:pt>
                <c:pt idx="6">
                  <c:v>32µM</c:v>
                </c:pt>
              </c:strCache>
            </c:strRef>
          </c:cat>
          <c:val>
            <c:numRef>
              <c:f>SJSA_nut_pd0332991!$K$17:$Q$17</c:f>
              <c:numCache>
                <c:formatCode>General</c:formatCode>
                <c:ptCount val="7"/>
                <c:pt idx="0">
                  <c:v>0.42765423051479512</c:v>
                </c:pt>
                <c:pt idx="1">
                  <c:v>0.50237222176595819</c:v>
                </c:pt>
                <c:pt idx="2">
                  <c:v>0.58103504137512152</c:v>
                </c:pt>
                <c:pt idx="3">
                  <c:v>0.57725176055225791</c:v>
                </c:pt>
                <c:pt idx="4">
                  <c:v>0.5583263314359771</c:v>
                </c:pt>
                <c:pt idx="5">
                  <c:v>1.9081561650239658E-2</c:v>
                </c:pt>
                <c:pt idx="6">
                  <c:v>7.2163915695651667E-3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SJSA_nut_pd0332991!$J$18</c:f>
              <c:strCache>
                <c:ptCount val="1"/>
                <c:pt idx="0">
                  <c:v>2µM</c:v>
                </c:pt>
              </c:strCache>
            </c:strRef>
          </c:tx>
          <c:cat>
            <c:strRef>
              <c:f>SJSA_nut_pd0332991!$K$14:$Q$14</c:f>
              <c:strCache>
                <c:ptCount val="7"/>
                <c:pt idx="0">
                  <c:v>water</c:v>
                </c:pt>
                <c:pt idx="1">
                  <c:v>1µM</c:v>
                </c:pt>
                <c:pt idx="2">
                  <c:v>2µM</c:v>
                </c:pt>
                <c:pt idx="3">
                  <c:v>4µM</c:v>
                </c:pt>
                <c:pt idx="4">
                  <c:v>8µM</c:v>
                </c:pt>
                <c:pt idx="5">
                  <c:v>16µM</c:v>
                </c:pt>
                <c:pt idx="6">
                  <c:v>32µM</c:v>
                </c:pt>
              </c:strCache>
            </c:strRef>
          </c:cat>
          <c:val>
            <c:numRef>
              <c:f>SJSA_nut_pd0332991!$K$18:$Q$18</c:f>
              <c:numCache>
                <c:formatCode>General</c:formatCode>
                <c:ptCount val="7"/>
                <c:pt idx="0">
                  <c:v>0.69858027694121028</c:v>
                </c:pt>
                <c:pt idx="1">
                  <c:v>0.66694132755973878</c:v>
                </c:pt>
                <c:pt idx="2">
                  <c:v>0.73444292724133664</c:v>
                </c:pt>
                <c:pt idx="3">
                  <c:v>0.61580656893792873</c:v>
                </c:pt>
                <c:pt idx="4">
                  <c:v>0.42215168681799187</c:v>
                </c:pt>
                <c:pt idx="5">
                  <c:v>2.9355623884848196E-2</c:v>
                </c:pt>
                <c:pt idx="6">
                  <c:v>8.8228419189681166E-3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SJSA_nut_pd0332991!$J$19</c:f>
              <c:strCache>
                <c:ptCount val="1"/>
                <c:pt idx="0">
                  <c:v>1µM</c:v>
                </c:pt>
              </c:strCache>
            </c:strRef>
          </c:tx>
          <c:cat>
            <c:strRef>
              <c:f>SJSA_nut_pd0332991!$K$14:$Q$14</c:f>
              <c:strCache>
                <c:ptCount val="7"/>
                <c:pt idx="0">
                  <c:v>water</c:v>
                </c:pt>
                <c:pt idx="1">
                  <c:v>1µM</c:v>
                </c:pt>
                <c:pt idx="2">
                  <c:v>2µM</c:v>
                </c:pt>
                <c:pt idx="3">
                  <c:v>4µM</c:v>
                </c:pt>
                <c:pt idx="4">
                  <c:v>8µM</c:v>
                </c:pt>
                <c:pt idx="5">
                  <c:v>16µM</c:v>
                </c:pt>
                <c:pt idx="6">
                  <c:v>32µM</c:v>
                </c:pt>
              </c:strCache>
            </c:strRef>
          </c:cat>
          <c:val>
            <c:numRef>
              <c:f>SJSA_nut_pd0332991!$K$19:$Q$19</c:f>
              <c:numCache>
                <c:formatCode>General</c:formatCode>
                <c:ptCount val="7"/>
                <c:pt idx="0">
                  <c:v>0.89406723445962355</c:v>
                </c:pt>
                <c:pt idx="1">
                  <c:v>0.67953662029921491</c:v>
                </c:pt>
                <c:pt idx="2">
                  <c:v>0.62456533334296005</c:v>
                </c:pt>
                <c:pt idx="3">
                  <c:v>0.57624186283260515</c:v>
                </c:pt>
                <c:pt idx="4">
                  <c:v>0.49441487753523589</c:v>
                </c:pt>
                <c:pt idx="5">
                  <c:v>2.5083187955593382E-2</c:v>
                </c:pt>
                <c:pt idx="6">
                  <c:v>1.0177494713605101E-2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SJSA_nut_pd0332991!$J$20</c:f>
              <c:strCache>
                <c:ptCount val="1"/>
                <c:pt idx="0">
                  <c:v>DMSO</c:v>
                </c:pt>
              </c:strCache>
            </c:strRef>
          </c:tx>
          <c:cat>
            <c:strRef>
              <c:f>SJSA_nut_pd0332991!$K$14:$Q$14</c:f>
              <c:strCache>
                <c:ptCount val="7"/>
                <c:pt idx="0">
                  <c:v>water</c:v>
                </c:pt>
                <c:pt idx="1">
                  <c:v>1µM</c:v>
                </c:pt>
                <c:pt idx="2">
                  <c:v>2µM</c:v>
                </c:pt>
                <c:pt idx="3">
                  <c:v>4µM</c:v>
                </c:pt>
                <c:pt idx="4">
                  <c:v>8µM</c:v>
                </c:pt>
                <c:pt idx="5">
                  <c:v>16µM</c:v>
                </c:pt>
                <c:pt idx="6">
                  <c:v>32µM</c:v>
                </c:pt>
              </c:strCache>
            </c:strRef>
          </c:cat>
          <c:val>
            <c:numRef>
              <c:f>SJSA_nut_pd0332991!$K$20:$Q$20</c:f>
              <c:numCache>
                <c:formatCode>General</c:formatCode>
                <c:ptCount val="7"/>
                <c:pt idx="0">
                  <c:v>1</c:v>
                </c:pt>
                <c:pt idx="1">
                  <c:v>0.697360096675821</c:v>
                </c:pt>
                <c:pt idx="2">
                  <c:v>0.65645156777821601</c:v>
                </c:pt>
                <c:pt idx="3">
                  <c:v>0.70531292840556192</c:v>
                </c:pt>
                <c:pt idx="4">
                  <c:v>0.59677374229828895</c:v>
                </c:pt>
                <c:pt idx="5">
                  <c:v>2.3068807517465637E-2</c:v>
                </c:pt>
                <c:pt idx="6">
                  <c:v>8.9203119401678466E-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98040952"/>
        <c:axId val="398039776"/>
      </c:lineChart>
      <c:catAx>
        <c:axId val="39804095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0" vert="horz"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98039776"/>
        <c:crosses val="autoZero"/>
        <c:auto val="1"/>
        <c:lblAlgn val="ctr"/>
        <c:lblOffset val="100"/>
        <c:tickLblSkip val="1"/>
        <c:noMultiLvlLbl val="0"/>
      </c:catAx>
      <c:valAx>
        <c:axId val="3980397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98040952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CRL3043'!$K$26</c:f>
              <c:strCache>
                <c:ptCount val="1"/>
                <c:pt idx="0">
                  <c:v>16µM</c:v>
                </c:pt>
              </c:strCache>
            </c:strRef>
          </c:tx>
          <c:cat>
            <c:strRef>
              <c:f>'CRL3043'!$L$25:$R$25</c:f>
              <c:strCache>
                <c:ptCount val="7"/>
                <c:pt idx="0">
                  <c:v>water</c:v>
                </c:pt>
                <c:pt idx="1">
                  <c:v>1µM</c:v>
                </c:pt>
                <c:pt idx="2">
                  <c:v>2µM</c:v>
                </c:pt>
                <c:pt idx="3">
                  <c:v>4µM</c:v>
                </c:pt>
                <c:pt idx="4">
                  <c:v>8µM</c:v>
                </c:pt>
                <c:pt idx="5">
                  <c:v>16µM</c:v>
                </c:pt>
                <c:pt idx="6">
                  <c:v>32µM</c:v>
                </c:pt>
              </c:strCache>
            </c:strRef>
          </c:cat>
          <c:val>
            <c:numRef>
              <c:f>'CRL3043'!$L$26:$R$26</c:f>
              <c:numCache>
                <c:formatCode>General</c:formatCode>
                <c:ptCount val="7"/>
                <c:pt idx="0">
                  <c:v>1.1701444114495387E-2</c:v>
                </c:pt>
                <c:pt idx="1">
                  <c:v>5.0483227249093149E-3</c:v>
                </c:pt>
                <c:pt idx="2">
                  <c:v>9.1476588428901079E-3</c:v>
                </c:pt>
                <c:pt idx="3">
                  <c:v>1.3039627596816553E-2</c:v>
                </c:pt>
                <c:pt idx="4">
                  <c:v>9.9750852708902181E-3</c:v>
                </c:pt>
                <c:pt idx="5">
                  <c:v>6.3844631790131972E-4</c:v>
                </c:pt>
                <c:pt idx="6">
                  <c:v>3.4629328282967582E-4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CRL3043'!$K$27</c:f>
              <c:strCache>
                <c:ptCount val="1"/>
                <c:pt idx="0">
                  <c:v>8µM</c:v>
                </c:pt>
              </c:strCache>
            </c:strRef>
          </c:tx>
          <c:cat>
            <c:strRef>
              <c:f>'CRL3043'!$L$25:$R$25</c:f>
              <c:strCache>
                <c:ptCount val="7"/>
                <c:pt idx="0">
                  <c:v>water</c:v>
                </c:pt>
                <c:pt idx="1">
                  <c:v>1µM</c:v>
                </c:pt>
                <c:pt idx="2">
                  <c:v>2µM</c:v>
                </c:pt>
                <c:pt idx="3">
                  <c:v>4µM</c:v>
                </c:pt>
                <c:pt idx="4">
                  <c:v>8µM</c:v>
                </c:pt>
                <c:pt idx="5">
                  <c:v>16µM</c:v>
                </c:pt>
                <c:pt idx="6">
                  <c:v>32µM</c:v>
                </c:pt>
              </c:strCache>
            </c:strRef>
          </c:cat>
          <c:val>
            <c:numRef>
              <c:f>'CRL3043'!$L$27:$R$27</c:f>
              <c:numCache>
                <c:formatCode>General</c:formatCode>
                <c:ptCount val="7"/>
                <c:pt idx="0">
                  <c:v>0.18425662886042951</c:v>
                </c:pt>
                <c:pt idx="1">
                  <c:v>0.19061861872905259</c:v>
                </c:pt>
                <c:pt idx="2">
                  <c:v>0.20185833846644172</c:v>
                </c:pt>
                <c:pt idx="3">
                  <c:v>0.25885984724278022</c:v>
                </c:pt>
                <c:pt idx="4">
                  <c:v>0.13455383839033894</c:v>
                </c:pt>
                <c:pt idx="5">
                  <c:v>6.9973716441984642E-4</c:v>
                </c:pt>
                <c:pt idx="6">
                  <c:v>4.1984229865190781E-4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CRL3043'!$K$28</c:f>
              <c:strCache>
                <c:ptCount val="1"/>
                <c:pt idx="0">
                  <c:v>4µM</c:v>
                </c:pt>
              </c:strCache>
            </c:strRef>
          </c:tx>
          <c:cat>
            <c:strRef>
              <c:f>'CRL3043'!$L$25:$R$25</c:f>
              <c:strCache>
                <c:ptCount val="7"/>
                <c:pt idx="0">
                  <c:v>water</c:v>
                </c:pt>
                <c:pt idx="1">
                  <c:v>1µM</c:v>
                </c:pt>
                <c:pt idx="2">
                  <c:v>2µM</c:v>
                </c:pt>
                <c:pt idx="3">
                  <c:v>4µM</c:v>
                </c:pt>
                <c:pt idx="4">
                  <c:v>8µM</c:v>
                </c:pt>
                <c:pt idx="5">
                  <c:v>16µM</c:v>
                </c:pt>
                <c:pt idx="6">
                  <c:v>32µM</c:v>
                </c:pt>
              </c:strCache>
            </c:strRef>
          </c:cat>
          <c:val>
            <c:numRef>
              <c:f>'CRL3043'!$L$28:$R$28</c:f>
              <c:numCache>
                <c:formatCode>General</c:formatCode>
                <c:ptCount val="7"/>
                <c:pt idx="0">
                  <c:v>0.46588806861305965</c:v>
                </c:pt>
                <c:pt idx="1">
                  <c:v>0.64127182592582377</c:v>
                </c:pt>
                <c:pt idx="2">
                  <c:v>0.52180677243423745</c:v>
                </c:pt>
                <c:pt idx="3">
                  <c:v>0.55968042952625241</c:v>
                </c:pt>
                <c:pt idx="4">
                  <c:v>0.47139913722918386</c:v>
                </c:pt>
                <c:pt idx="5">
                  <c:v>1.13694520291867E-3</c:v>
                </c:pt>
                <c:pt idx="6">
                  <c:v>5.4753156223217182E-4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CRL3043'!$K$29</c:f>
              <c:strCache>
                <c:ptCount val="1"/>
                <c:pt idx="0">
                  <c:v>2µM</c:v>
                </c:pt>
              </c:strCache>
            </c:strRef>
          </c:tx>
          <c:cat>
            <c:strRef>
              <c:f>'CRL3043'!$L$25:$R$25</c:f>
              <c:strCache>
                <c:ptCount val="7"/>
                <c:pt idx="0">
                  <c:v>water</c:v>
                </c:pt>
                <c:pt idx="1">
                  <c:v>1µM</c:v>
                </c:pt>
                <c:pt idx="2">
                  <c:v>2µM</c:v>
                </c:pt>
                <c:pt idx="3">
                  <c:v>4µM</c:v>
                </c:pt>
                <c:pt idx="4">
                  <c:v>8µM</c:v>
                </c:pt>
                <c:pt idx="5">
                  <c:v>16µM</c:v>
                </c:pt>
                <c:pt idx="6">
                  <c:v>32µM</c:v>
                </c:pt>
              </c:strCache>
            </c:strRef>
          </c:cat>
          <c:val>
            <c:numRef>
              <c:f>'CRL3043'!$L$29:$R$29</c:f>
              <c:numCache>
                <c:formatCode>General</c:formatCode>
                <c:ptCount val="7"/>
                <c:pt idx="0">
                  <c:v>0.71808866538160188</c:v>
                </c:pt>
                <c:pt idx="1">
                  <c:v>1.1307773007306889</c:v>
                </c:pt>
                <c:pt idx="2">
                  <c:v>1.0031503495110523</c:v>
                </c:pt>
                <c:pt idx="3">
                  <c:v>0.82581447873667302</c:v>
                </c:pt>
                <c:pt idx="4">
                  <c:v>0.6825992222191577</c:v>
                </c:pt>
                <c:pt idx="5">
                  <c:v>1.6364656020446627E-3</c:v>
                </c:pt>
                <c:pt idx="6">
                  <c:v>5.2914430827661371E-4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'CRL3043'!$K$30</c:f>
              <c:strCache>
                <c:ptCount val="1"/>
                <c:pt idx="0">
                  <c:v>1µM</c:v>
                </c:pt>
              </c:strCache>
            </c:strRef>
          </c:tx>
          <c:cat>
            <c:strRef>
              <c:f>'CRL3043'!$L$25:$R$25</c:f>
              <c:strCache>
                <c:ptCount val="7"/>
                <c:pt idx="0">
                  <c:v>water</c:v>
                </c:pt>
                <c:pt idx="1">
                  <c:v>1µM</c:v>
                </c:pt>
                <c:pt idx="2">
                  <c:v>2µM</c:v>
                </c:pt>
                <c:pt idx="3">
                  <c:v>4µM</c:v>
                </c:pt>
                <c:pt idx="4">
                  <c:v>8µM</c:v>
                </c:pt>
                <c:pt idx="5">
                  <c:v>16µM</c:v>
                </c:pt>
                <c:pt idx="6">
                  <c:v>32µM</c:v>
                </c:pt>
              </c:strCache>
            </c:strRef>
          </c:cat>
          <c:val>
            <c:numRef>
              <c:f>'CRL3043'!$L$30:$R$30</c:f>
              <c:numCache>
                <c:formatCode>General</c:formatCode>
                <c:ptCount val="7"/>
                <c:pt idx="0">
                  <c:v>1.0032116403575708</c:v>
                </c:pt>
                <c:pt idx="1">
                  <c:v>1.2544438417511203</c:v>
                </c:pt>
                <c:pt idx="2">
                  <c:v>0.99023841117781597</c:v>
                </c:pt>
                <c:pt idx="3">
                  <c:v>0.83389159079370623</c:v>
                </c:pt>
                <c:pt idx="4">
                  <c:v>0.99090137383432475</c:v>
                </c:pt>
                <c:pt idx="5">
                  <c:v>4.3853600684005851E-3</c:v>
                </c:pt>
                <c:pt idx="6">
                  <c:v>4.8624071571364507E-4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'CRL3043'!$K$31</c:f>
              <c:strCache>
                <c:ptCount val="1"/>
                <c:pt idx="0">
                  <c:v>DMSO</c:v>
                </c:pt>
              </c:strCache>
            </c:strRef>
          </c:tx>
          <c:cat>
            <c:strRef>
              <c:f>'CRL3043'!$L$25:$R$25</c:f>
              <c:strCache>
                <c:ptCount val="7"/>
                <c:pt idx="0">
                  <c:v>water</c:v>
                </c:pt>
                <c:pt idx="1">
                  <c:v>1µM</c:v>
                </c:pt>
                <c:pt idx="2">
                  <c:v>2µM</c:v>
                </c:pt>
                <c:pt idx="3">
                  <c:v>4µM</c:v>
                </c:pt>
                <c:pt idx="4">
                  <c:v>8µM</c:v>
                </c:pt>
                <c:pt idx="5">
                  <c:v>16µM</c:v>
                </c:pt>
                <c:pt idx="6">
                  <c:v>32µM</c:v>
                </c:pt>
              </c:strCache>
            </c:strRef>
          </c:cat>
          <c:val>
            <c:numRef>
              <c:f>'CRL3043'!$L$31:$R$31</c:f>
              <c:numCache>
                <c:formatCode>General</c:formatCode>
                <c:ptCount val="7"/>
                <c:pt idx="0">
                  <c:v>1</c:v>
                </c:pt>
                <c:pt idx="1">
                  <c:v>0.84931543232009354</c:v>
                </c:pt>
                <c:pt idx="2">
                  <c:v>0.94358790486434807</c:v>
                </c:pt>
                <c:pt idx="3">
                  <c:v>1.0332145312424983</c:v>
                </c:pt>
                <c:pt idx="4">
                  <c:v>0.94547361990890133</c:v>
                </c:pt>
                <c:pt idx="5">
                  <c:v>1.4168400686866086E-3</c:v>
                </c:pt>
                <c:pt idx="6">
                  <c:v>1.0092559393384062E-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04523576"/>
        <c:axId val="504524752"/>
      </c:lineChart>
      <c:catAx>
        <c:axId val="5045235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504524752"/>
        <c:crosses val="autoZero"/>
        <c:auto val="1"/>
        <c:lblAlgn val="ctr"/>
        <c:lblOffset val="100"/>
        <c:noMultiLvlLbl val="0"/>
      </c:catAx>
      <c:valAx>
        <c:axId val="5045247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504523576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 sz="1000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6.5113517060367457E-2"/>
          <c:y val="7.4548702245552642E-2"/>
          <c:w val="0.71845581802274716"/>
          <c:h val="0.8326195683872849"/>
        </c:manualLayout>
      </c:layout>
      <c:lineChart>
        <c:grouping val="standard"/>
        <c:varyColors val="0"/>
        <c:ser>
          <c:idx val="0"/>
          <c:order val="0"/>
          <c:tx>
            <c:strRef>
              <c:f>'CRL3044'!$N$14</c:f>
              <c:strCache>
                <c:ptCount val="1"/>
                <c:pt idx="0">
                  <c:v>16µM</c:v>
                </c:pt>
              </c:strCache>
            </c:strRef>
          </c:tx>
          <c:cat>
            <c:strRef>
              <c:f>'CRL3044'!$O$13:$U$13</c:f>
              <c:strCache>
                <c:ptCount val="7"/>
                <c:pt idx="0">
                  <c:v>water</c:v>
                </c:pt>
                <c:pt idx="1">
                  <c:v>1µM</c:v>
                </c:pt>
                <c:pt idx="2">
                  <c:v>2µM</c:v>
                </c:pt>
                <c:pt idx="3">
                  <c:v>4µM</c:v>
                </c:pt>
                <c:pt idx="4">
                  <c:v>8µM</c:v>
                </c:pt>
                <c:pt idx="5">
                  <c:v>16µM</c:v>
                </c:pt>
                <c:pt idx="6">
                  <c:v>32µM</c:v>
                </c:pt>
              </c:strCache>
            </c:strRef>
          </c:cat>
          <c:val>
            <c:numRef>
              <c:f>'CRL3044'!$O$14:$U$14</c:f>
              <c:numCache>
                <c:formatCode>General</c:formatCode>
                <c:ptCount val="7"/>
                <c:pt idx="0">
                  <c:v>7.0558597053954314E-2</c:v>
                </c:pt>
                <c:pt idx="1">
                  <c:v>3.0883760543625363E-2</c:v>
                </c:pt>
                <c:pt idx="2">
                  <c:v>1.1904325561913993E-2</c:v>
                </c:pt>
                <c:pt idx="3">
                  <c:v>1.3192209797265254E-2</c:v>
                </c:pt>
                <c:pt idx="4">
                  <c:v>1.197427365203735E-2</c:v>
                </c:pt>
                <c:pt idx="5">
                  <c:v>3.9646577481919121E-4</c:v>
                </c:pt>
                <c:pt idx="6">
                  <c:v>3.1308765139214886E-4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CRL3044'!$N$15</c:f>
              <c:strCache>
                <c:ptCount val="1"/>
                <c:pt idx="0">
                  <c:v>8µM</c:v>
                </c:pt>
              </c:strCache>
            </c:strRef>
          </c:tx>
          <c:cat>
            <c:strRef>
              <c:f>'CRL3044'!$O$13:$U$13</c:f>
              <c:strCache>
                <c:ptCount val="7"/>
                <c:pt idx="0">
                  <c:v>water</c:v>
                </c:pt>
                <c:pt idx="1">
                  <c:v>1µM</c:v>
                </c:pt>
                <c:pt idx="2">
                  <c:v>2µM</c:v>
                </c:pt>
                <c:pt idx="3">
                  <c:v>4µM</c:v>
                </c:pt>
                <c:pt idx="4">
                  <c:v>8µM</c:v>
                </c:pt>
                <c:pt idx="5">
                  <c:v>16µM</c:v>
                </c:pt>
                <c:pt idx="6">
                  <c:v>32µM</c:v>
                </c:pt>
              </c:strCache>
            </c:strRef>
          </c:cat>
          <c:val>
            <c:numRef>
              <c:f>'CRL3044'!$O$15:$U$15</c:f>
              <c:numCache>
                <c:formatCode>General</c:formatCode>
                <c:ptCount val="7"/>
                <c:pt idx="0">
                  <c:v>0.29116815828637249</c:v>
                </c:pt>
                <c:pt idx="1">
                  <c:v>0.29582110524137828</c:v>
                </c:pt>
                <c:pt idx="2">
                  <c:v>0.12583073849235005</c:v>
                </c:pt>
                <c:pt idx="3">
                  <c:v>0.24978435003814969</c:v>
                </c:pt>
                <c:pt idx="4">
                  <c:v>0.14987301623719004</c:v>
                </c:pt>
                <c:pt idx="5">
                  <c:v>1.1477082627440523E-3</c:v>
                </c:pt>
                <c:pt idx="6">
                  <c:v>3.1644515971807004E-4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CRL3044'!$N$16</c:f>
              <c:strCache>
                <c:ptCount val="1"/>
                <c:pt idx="0">
                  <c:v>4µM</c:v>
                </c:pt>
              </c:strCache>
            </c:strRef>
          </c:tx>
          <c:cat>
            <c:strRef>
              <c:f>'CRL3044'!$O$13:$U$13</c:f>
              <c:strCache>
                <c:ptCount val="7"/>
                <c:pt idx="0">
                  <c:v>water</c:v>
                </c:pt>
                <c:pt idx="1">
                  <c:v>1µM</c:v>
                </c:pt>
                <c:pt idx="2">
                  <c:v>2µM</c:v>
                </c:pt>
                <c:pt idx="3">
                  <c:v>4µM</c:v>
                </c:pt>
                <c:pt idx="4">
                  <c:v>8µM</c:v>
                </c:pt>
                <c:pt idx="5">
                  <c:v>16µM</c:v>
                </c:pt>
                <c:pt idx="6">
                  <c:v>32µM</c:v>
                </c:pt>
              </c:strCache>
            </c:strRef>
          </c:cat>
          <c:val>
            <c:numRef>
              <c:f>'CRL3044'!$O$16:$U$16</c:f>
              <c:numCache>
                <c:formatCode>General</c:formatCode>
                <c:ptCount val="7"/>
                <c:pt idx="0">
                  <c:v>0.5446824202822601</c:v>
                </c:pt>
                <c:pt idx="1">
                  <c:v>0.45066994881758349</c:v>
                </c:pt>
                <c:pt idx="2">
                  <c:v>0.38927706970103348</c:v>
                </c:pt>
                <c:pt idx="3">
                  <c:v>0.4373845681642739</c:v>
                </c:pt>
                <c:pt idx="4">
                  <c:v>0.51806325489727567</c:v>
                </c:pt>
                <c:pt idx="5">
                  <c:v>2.5405146332803498E-3</c:v>
                </c:pt>
                <c:pt idx="6">
                  <c:v>3.1644515971807004E-4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CRL3044'!$N$17</c:f>
              <c:strCache>
                <c:ptCount val="1"/>
                <c:pt idx="0">
                  <c:v>2µM</c:v>
                </c:pt>
              </c:strCache>
            </c:strRef>
          </c:tx>
          <c:cat>
            <c:strRef>
              <c:f>'CRL3044'!$O$13:$U$13</c:f>
              <c:strCache>
                <c:ptCount val="7"/>
                <c:pt idx="0">
                  <c:v>water</c:v>
                </c:pt>
                <c:pt idx="1">
                  <c:v>1µM</c:v>
                </c:pt>
                <c:pt idx="2">
                  <c:v>2µM</c:v>
                </c:pt>
                <c:pt idx="3">
                  <c:v>4µM</c:v>
                </c:pt>
                <c:pt idx="4">
                  <c:v>8µM</c:v>
                </c:pt>
                <c:pt idx="5">
                  <c:v>16µM</c:v>
                </c:pt>
                <c:pt idx="6">
                  <c:v>32µM</c:v>
                </c:pt>
              </c:strCache>
            </c:strRef>
          </c:cat>
          <c:val>
            <c:numRef>
              <c:f>'CRL3044'!$O$17:$U$17</c:f>
              <c:numCache>
                <c:formatCode>General</c:formatCode>
                <c:ptCount val="7"/>
                <c:pt idx="0">
                  <c:v>0.76486557795728638</c:v>
                </c:pt>
                <c:pt idx="1">
                  <c:v>0.58008902433326182</c:v>
                </c:pt>
                <c:pt idx="2">
                  <c:v>0.5373708863178458</c:v>
                </c:pt>
                <c:pt idx="3">
                  <c:v>0.4883655341697819</c:v>
                </c:pt>
                <c:pt idx="4">
                  <c:v>0.56397494291536365</c:v>
                </c:pt>
                <c:pt idx="5">
                  <c:v>5.3675366437059731E-3</c:v>
                </c:pt>
                <c:pt idx="6">
                  <c:v>4.0485954563399408E-4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'CRL3044'!$N$18</c:f>
              <c:strCache>
                <c:ptCount val="1"/>
                <c:pt idx="0">
                  <c:v>1µM</c:v>
                </c:pt>
              </c:strCache>
            </c:strRef>
          </c:tx>
          <c:cat>
            <c:strRef>
              <c:f>'CRL3044'!$O$13:$U$13</c:f>
              <c:strCache>
                <c:ptCount val="7"/>
                <c:pt idx="0">
                  <c:v>water</c:v>
                </c:pt>
                <c:pt idx="1">
                  <c:v>1µM</c:v>
                </c:pt>
                <c:pt idx="2">
                  <c:v>2µM</c:v>
                </c:pt>
                <c:pt idx="3">
                  <c:v>4µM</c:v>
                </c:pt>
                <c:pt idx="4">
                  <c:v>8µM</c:v>
                </c:pt>
                <c:pt idx="5">
                  <c:v>16µM</c:v>
                </c:pt>
                <c:pt idx="6">
                  <c:v>32µM</c:v>
                </c:pt>
              </c:strCache>
            </c:strRef>
          </c:cat>
          <c:val>
            <c:numRef>
              <c:f>'CRL3044'!$O$18:$U$18</c:f>
              <c:numCache>
                <c:formatCode>General</c:formatCode>
                <c:ptCount val="7"/>
                <c:pt idx="0">
                  <c:v>1.1123654513512433</c:v>
                </c:pt>
                <c:pt idx="1">
                  <c:v>0.58988763259010224</c:v>
                </c:pt>
                <c:pt idx="2">
                  <c:v>0.59019260626304004</c:v>
                </c:pt>
                <c:pt idx="3">
                  <c:v>0.52842844268411526</c:v>
                </c:pt>
                <c:pt idx="4">
                  <c:v>0.7133429339418631</c:v>
                </c:pt>
                <c:pt idx="5">
                  <c:v>7.8879062270307953E-3</c:v>
                </c:pt>
                <c:pt idx="6">
                  <c:v>3.1308765139214886E-4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'CRL3044'!$N$19</c:f>
              <c:strCache>
                <c:ptCount val="1"/>
                <c:pt idx="0">
                  <c:v>DMSO</c:v>
                </c:pt>
              </c:strCache>
            </c:strRef>
          </c:tx>
          <c:cat>
            <c:strRef>
              <c:f>'CRL3044'!$O$13:$U$13</c:f>
              <c:strCache>
                <c:ptCount val="7"/>
                <c:pt idx="0">
                  <c:v>water</c:v>
                </c:pt>
                <c:pt idx="1">
                  <c:v>1µM</c:v>
                </c:pt>
                <c:pt idx="2">
                  <c:v>2µM</c:v>
                </c:pt>
                <c:pt idx="3">
                  <c:v>4µM</c:v>
                </c:pt>
                <c:pt idx="4">
                  <c:v>8µM</c:v>
                </c:pt>
                <c:pt idx="5">
                  <c:v>16µM</c:v>
                </c:pt>
                <c:pt idx="6">
                  <c:v>32µM</c:v>
                </c:pt>
              </c:strCache>
            </c:strRef>
          </c:cat>
          <c:val>
            <c:numRef>
              <c:f>'CRL3044'!$O$19:$U$19</c:f>
              <c:numCache>
                <c:formatCode>General</c:formatCode>
                <c:ptCount val="7"/>
                <c:pt idx="0">
                  <c:v>1</c:v>
                </c:pt>
                <c:pt idx="1">
                  <c:v>0.65071085446068766</c:v>
                </c:pt>
                <c:pt idx="2">
                  <c:v>0.6446236918657926</c:v>
                </c:pt>
                <c:pt idx="3">
                  <c:v>0.67231082469078052</c:v>
                </c:pt>
                <c:pt idx="4">
                  <c:v>0.6949533012560718</c:v>
                </c:pt>
                <c:pt idx="5">
                  <c:v>4.0446783632930331E-3</c:v>
                </c:pt>
                <c:pt idx="6">
                  <c:v>3.6149172975751237E-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04525144"/>
        <c:axId val="483004296"/>
      </c:lineChart>
      <c:catAx>
        <c:axId val="50452514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483004296"/>
        <c:crosses val="autoZero"/>
        <c:auto val="1"/>
        <c:lblAlgn val="ctr"/>
        <c:lblOffset val="100"/>
        <c:noMultiLvlLbl val="0"/>
      </c:catAx>
      <c:valAx>
        <c:axId val="4830042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50452514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7057537994731273"/>
          <c:y val="0.18611988280110819"/>
          <c:w val="0.21788260712563284"/>
          <c:h val="0.5907232429279673"/>
        </c:manualLayout>
      </c:layout>
      <c:overlay val="0"/>
      <c:txPr>
        <a:bodyPr/>
        <a:lstStyle/>
        <a:p>
          <a:pPr>
            <a:defRPr sz="1000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GOT-3'!$K$13</c:f>
              <c:strCache>
                <c:ptCount val="1"/>
                <c:pt idx="0">
                  <c:v>16µM</c:v>
                </c:pt>
              </c:strCache>
            </c:strRef>
          </c:tx>
          <c:cat>
            <c:strRef>
              <c:f>'GOT-3'!$L$12:$R$12</c:f>
              <c:strCache>
                <c:ptCount val="7"/>
                <c:pt idx="0">
                  <c:v>water</c:v>
                </c:pt>
                <c:pt idx="1">
                  <c:v>1µM</c:v>
                </c:pt>
                <c:pt idx="2">
                  <c:v>2µM</c:v>
                </c:pt>
                <c:pt idx="3">
                  <c:v>4µM</c:v>
                </c:pt>
                <c:pt idx="4">
                  <c:v>8µM</c:v>
                </c:pt>
                <c:pt idx="5">
                  <c:v>16µM</c:v>
                </c:pt>
                <c:pt idx="6">
                  <c:v>32µM</c:v>
                </c:pt>
              </c:strCache>
            </c:strRef>
          </c:cat>
          <c:val>
            <c:numRef>
              <c:f>'GOT-3'!$L$13:$R$13</c:f>
              <c:numCache>
                <c:formatCode>General</c:formatCode>
                <c:ptCount val="7"/>
                <c:pt idx="0">
                  <c:v>0.38777481267824782</c:v>
                </c:pt>
                <c:pt idx="1">
                  <c:v>0.41292752755968481</c:v>
                </c:pt>
                <c:pt idx="2">
                  <c:v>0.36292611433089822</c:v>
                </c:pt>
                <c:pt idx="3">
                  <c:v>0.36426833698819577</c:v>
                </c:pt>
                <c:pt idx="4">
                  <c:v>0.40923796635688231</c:v>
                </c:pt>
                <c:pt idx="5">
                  <c:v>2.0316025531873826E-3</c:v>
                </c:pt>
                <c:pt idx="6">
                  <c:v>4.3913499368183326E-4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GOT-3'!$K$14</c:f>
              <c:strCache>
                <c:ptCount val="1"/>
                <c:pt idx="0">
                  <c:v>8µM</c:v>
                </c:pt>
              </c:strCache>
            </c:strRef>
          </c:tx>
          <c:cat>
            <c:strRef>
              <c:f>'GOT-3'!$L$12:$R$12</c:f>
              <c:strCache>
                <c:ptCount val="7"/>
                <c:pt idx="0">
                  <c:v>water</c:v>
                </c:pt>
                <c:pt idx="1">
                  <c:v>1µM</c:v>
                </c:pt>
                <c:pt idx="2">
                  <c:v>2µM</c:v>
                </c:pt>
                <c:pt idx="3">
                  <c:v>4µM</c:v>
                </c:pt>
                <c:pt idx="4">
                  <c:v>8µM</c:v>
                </c:pt>
                <c:pt idx="5">
                  <c:v>16µM</c:v>
                </c:pt>
                <c:pt idx="6">
                  <c:v>32µM</c:v>
                </c:pt>
              </c:strCache>
            </c:strRef>
          </c:cat>
          <c:val>
            <c:numRef>
              <c:f>'GOT-3'!$L$14:$R$14</c:f>
              <c:numCache>
                <c:formatCode>General</c:formatCode>
                <c:ptCount val="7"/>
                <c:pt idx="0">
                  <c:v>0.87286938525926538</c:v>
                </c:pt>
                <c:pt idx="1">
                  <c:v>0.57318629319740599</c:v>
                </c:pt>
                <c:pt idx="2">
                  <c:v>0.67662567843599009</c:v>
                </c:pt>
                <c:pt idx="3">
                  <c:v>0.67411771437474277</c:v>
                </c:pt>
                <c:pt idx="4">
                  <c:v>0.52358678844792317</c:v>
                </c:pt>
                <c:pt idx="5">
                  <c:v>1.3422226572975342E-3</c:v>
                </c:pt>
                <c:pt idx="6">
                  <c:v>4.5154383180785051E-4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GOT-3'!$K$15</c:f>
              <c:strCache>
                <c:ptCount val="1"/>
                <c:pt idx="0">
                  <c:v>4µM</c:v>
                </c:pt>
              </c:strCache>
            </c:strRef>
          </c:tx>
          <c:cat>
            <c:strRef>
              <c:f>'GOT-3'!$L$12:$R$12</c:f>
              <c:strCache>
                <c:ptCount val="7"/>
                <c:pt idx="0">
                  <c:v>water</c:v>
                </c:pt>
                <c:pt idx="1">
                  <c:v>1µM</c:v>
                </c:pt>
                <c:pt idx="2">
                  <c:v>2µM</c:v>
                </c:pt>
                <c:pt idx="3">
                  <c:v>4µM</c:v>
                </c:pt>
                <c:pt idx="4">
                  <c:v>8µM</c:v>
                </c:pt>
                <c:pt idx="5">
                  <c:v>16µM</c:v>
                </c:pt>
                <c:pt idx="6">
                  <c:v>32µM</c:v>
                </c:pt>
              </c:strCache>
            </c:strRef>
          </c:cat>
          <c:val>
            <c:numRef>
              <c:f>'GOT-3'!$L$15:$R$15</c:f>
              <c:numCache>
                <c:formatCode>General</c:formatCode>
                <c:ptCount val="7"/>
                <c:pt idx="0">
                  <c:v>0.88793302536435448</c:v>
                </c:pt>
                <c:pt idx="1">
                  <c:v>0.67163043171037218</c:v>
                </c:pt>
                <c:pt idx="2">
                  <c:v>0.69734981686623065</c:v>
                </c:pt>
                <c:pt idx="3">
                  <c:v>0.69585937753131677</c:v>
                </c:pt>
                <c:pt idx="4">
                  <c:v>0.59899185084025064</c:v>
                </c:pt>
                <c:pt idx="5">
                  <c:v>1.0382061232101112E-3</c:v>
                </c:pt>
                <c:pt idx="6">
                  <c:v>3.5296250669560226E-4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GOT-3'!$K$16</c:f>
              <c:strCache>
                <c:ptCount val="1"/>
                <c:pt idx="0">
                  <c:v>2µM</c:v>
                </c:pt>
              </c:strCache>
            </c:strRef>
          </c:tx>
          <c:cat>
            <c:strRef>
              <c:f>'GOT-3'!$L$12:$R$12</c:f>
              <c:strCache>
                <c:ptCount val="7"/>
                <c:pt idx="0">
                  <c:v>water</c:v>
                </c:pt>
                <c:pt idx="1">
                  <c:v>1µM</c:v>
                </c:pt>
                <c:pt idx="2">
                  <c:v>2µM</c:v>
                </c:pt>
                <c:pt idx="3">
                  <c:v>4µM</c:v>
                </c:pt>
                <c:pt idx="4">
                  <c:v>8µM</c:v>
                </c:pt>
                <c:pt idx="5">
                  <c:v>16µM</c:v>
                </c:pt>
                <c:pt idx="6">
                  <c:v>32µM</c:v>
                </c:pt>
              </c:strCache>
            </c:strRef>
          </c:cat>
          <c:val>
            <c:numRef>
              <c:f>'GOT-3'!$L$16:$R$16</c:f>
              <c:numCache>
                <c:formatCode>General</c:formatCode>
                <c:ptCount val="7"/>
                <c:pt idx="0">
                  <c:v>0.92463216412205063</c:v>
                </c:pt>
                <c:pt idx="1">
                  <c:v>0.80181086311052341</c:v>
                </c:pt>
                <c:pt idx="2">
                  <c:v>0.8529125266531502</c:v>
                </c:pt>
                <c:pt idx="3">
                  <c:v>0.75645931727951388</c:v>
                </c:pt>
                <c:pt idx="4">
                  <c:v>0.57483253238879095</c:v>
                </c:pt>
                <c:pt idx="5">
                  <c:v>1.4814773962672837E-3</c:v>
                </c:pt>
                <c:pt idx="6">
                  <c:v>4.1018103805445962E-4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'GOT-3'!$K$17</c:f>
              <c:strCache>
                <c:ptCount val="1"/>
                <c:pt idx="0">
                  <c:v>1µM</c:v>
                </c:pt>
              </c:strCache>
            </c:strRef>
          </c:tx>
          <c:cat>
            <c:strRef>
              <c:f>'GOT-3'!$L$12:$R$12</c:f>
              <c:strCache>
                <c:ptCount val="7"/>
                <c:pt idx="0">
                  <c:v>water</c:v>
                </c:pt>
                <c:pt idx="1">
                  <c:v>1µM</c:v>
                </c:pt>
                <c:pt idx="2">
                  <c:v>2µM</c:v>
                </c:pt>
                <c:pt idx="3">
                  <c:v>4µM</c:v>
                </c:pt>
                <c:pt idx="4">
                  <c:v>8µM</c:v>
                </c:pt>
                <c:pt idx="5">
                  <c:v>16µM</c:v>
                </c:pt>
                <c:pt idx="6">
                  <c:v>32µM</c:v>
                </c:pt>
              </c:strCache>
            </c:strRef>
          </c:cat>
          <c:val>
            <c:numRef>
              <c:f>'GOT-3'!$L$17:$R$17</c:f>
              <c:numCache>
                <c:formatCode>General</c:formatCode>
                <c:ptCount val="7"/>
                <c:pt idx="0">
                  <c:v>1.0577017866658762</c:v>
                </c:pt>
                <c:pt idx="1">
                  <c:v>0.80588234077564891</c:v>
                </c:pt>
                <c:pt idx="2">
                  <c:v>0.83717191549029735</c:v>
                </c:pt>
                <c:pt idx="3">
                  <c:v>0.78343061632630828</c:v>
                </c:pt>
                <c:pt idx="4">
                  <c:v>0.68416197945785784</c:v>
                </c:pt>
                <c:pt idx="5">
                  <c:v>1.325677539796178E-3</c:v>
                </c:pt>
                <c:pt idx="6">
                  <c:v>4.3913499368183326E-4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'GOT-3'!$K$18</c:f>
              <c:strCache>
                <c:ptCount val="1"/>
                <c:pt idx="0">
                  <c:v>DMSO</c:v>
                </c:pt>
              </c:strCache>
            </c:strRef>
          </c:tx>
          <c:cat>
            <c:strRef>
              <c:f>'GOT-3'!$L$12:$R$12</c:f>
              <c:strCache>
                <c:ptCount val="7"/>
                <c:pt idx="0">
                  <c:v>water</c:v>
                </c:pt>
                <c:pt idx="1">
                  <c:v>1µM</c:v>
                </c:pt>
                <c:pt idx="2">
                  <c:v>2µM</c:v>
                </c:pt>
                <c:pt idx="3">
                  <c:v>4µM</c:v>
                </c:pt>
                <c:pt idx="4">
                  <c:v>8µM</c:v>
                </c:pt>
                <c:pt idx="5">
                  <c:v>16µM</c:v>
                </c:pt>
                <c:pt idx="6">
                  <c:v>32µM</c:v>
                </c:pt>
              </c:strCache>
            </c:strRef>
          </c:cat>
          <c:val>
            <c:numRef>
              <c:f>'GOT-3'!$L$18:$R$18</c:f>
              <c:numCache>
                <c:formatCode>General</c:formatCode>
                <c:ptCount val="7"/>
                <c:pt idx="0">
                  <c:v>1</c:v>
                </c:pt>
                <c:pt idx="1">
                  <c:v>0.86913432498333421</c:v>
                </c:pt>
                <c:pt idx="2">
                  <c:v>0.86468093085588582</c:v>
                </c:pt>
                <c:pt idx="3">
                  <c:v>0.83305080247266783</c:v>
                </c:pt>
                <c:pt idx="4">
                  <c:v>0.69603999506403991</c:v>
                </c:pt>
                <c:pt idx="5">
                  <c:v>1.7482674159766548E-3</c:v>
                </c:pt>
                <c:pt idx="6">
                  <c:v>4.5568011118318958E-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83004688"/>
        <c:axId val="483005080"/>
      </c:lineChart>
      <c:catAx>
        <c:axId val="4830046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483005080"/>
        <c:crosses val="autoZero"/>
        <c:auto val="1"/>
        <c:lblAlgn val="ctr"/>
        <c:lblOffset val="100"/>
        <c:noMultiLvlLbl val="0"/>
      </c:catAx>
      <c:valAx>
        <c:axId val="4830050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483004688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 sz="1000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35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37.emf"/><Relationship Id="rId1" Type="http://schemas.openxmlformats.org/officeDocument/2006/relationships/image" Target="../media/image36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6AD815-A1C5-496B-8B22-F18E74872307}" type="datetimeFigureOut">
              <a:rPr lang="en-US" smtClean="0"/>
              <a:t>5/15/2018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E9C1DC-C53F-4DCC-A441-56743544B8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0302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BD96ACB-7828-412E-9EDF-E2BEA9EF2509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394892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6D15251-14E1-404A-A624-968B093D95CB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813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10A8B-67BA-4B04-8018-1DB84BF8C5BB}" type="datetimeFigureOut">
              <a:rPr lang="en-US" smtClean="0"/>
              <a:t>5/15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F767A-1F1D-4DEF-BBF1-BB1F3E037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25465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10A8B-67BA-4B04-8018-1DB84BF8C5BB}" type="datetimeFigureOut">
              <a:rPr lang="en-US" smtClean="0"/>
              <a:t>5/15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F767A-1F1D-4DEF-BBF1-BB1F3E037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35296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10A8B-67BA-4B04-8018-1DB84BF8C5BB}" type="datetimeFigureOut">
              <a:rPr lang="en-US" smtClean="0"/>
              <a:t>5/15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F767A-1F1D-4DEF-BBF1-BB1F3E037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1089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10A8B-67BA-4B04-8018-1DB84BF8C5BB}" type="datetimeFigureOut">
              <a:rPr lang="en-US" smtClean="0"/>
              <a:t>5/15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F767A-1F1D-4DEF-BBF1-BB1F3E037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8258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10A8B-67BA-4B04-8018-1DB84BF8C5BB}" type="datetimeFigureOut">
              <a:rPr lang="en-US" smtClean="0"/>
              <a:t>5/15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F767A-1F1D-4DEF-BBF1-BB1F3E037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19704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10A8B-67BA-4B04-8018-1DB84BF8C5BB}" type="datetimeFigureOut">
              <a:rPr lang="en-US" smtClean="0"/>
              <a:t>5/15/2018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F767A-1F1D-4DEF-BBF1-BB1F3E037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34593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10A8B-67BA-4B04-8018-1DB84BF8C5BB}" type="datetimeFigureOut">
              <a:rPr lang="en-US" smtClean="0"/>
              <a:t>5/15/2018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F767A-1F1D-4DEF-BBF1-BB1F3E037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5633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10A8B-67BA-4B04-8018-1DB84BF8C5BB}" type="datetimeFigureOut">
              <a:rPr lang="en-US" smtClean="0"/>
              <a:t>5/15/2018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F767A-1F1D-4DEF-BBF1-BB1F3E037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0880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10A8B-67BA-4B04-8018-1DB84BF8C5BB}" type="datetimeFigureOut">
              <a:rPr lang="en-US" smtClean="0"/>
              <a:t>5/15/2018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F767A-1F1D-4DEF-BBF1-BB1F3E037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4754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10A8B-67BA-4B04-8018-1DB84BF8C5BB}" type="datetimeFigureOut">
              <a:rPr lang="en-US" smtClean="0"/>
              <a:t>5/15/2018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F767A-1F1D-4DEF-BBF1-BB1F3E037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01153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10A8B-67BA-4B04-8018-1DB84BF8C5BB}" type="datetimeFigureOut">
              <a:rPr lang="en-US" smtClean="0"/>
              <a:t>5/15/2018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F767A-1F1D-4DEF-BBF1-BB1F3E037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2610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310A8B-67BA-4B04-8018-1DB84BF8C5BB}" type="datetimeFigureOut">
              <a:rPr lang="en-US" smtClean="0"/>
              <a:t>5/15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FF767A-1F1D-4DEF-BBF1-BB1F3E037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37948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13" Type="http://schemas.openxmlformats.org/officeDocument/2006/relationships/image" Target="../media/image8.png"/><Relationship Id="rId3" Type="http://schemas.openxmlformats.org/officeDocument/2006/relationships/chart" Target="../charts/chart2.xml"/><Relationship Id="rId7" Type="http://schemas.openxmlformats.org/officeDocument/2006/relationships/image" Target="../media/image2.jpeg"/><Relationship Id="rId12" Type="http://schemas.openxmlformats.org/officeDocument/2006/relationships/image" Target="../media/image7.jpe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.jpeg"/><Relationship Id="rId11" Type="http://schemas.openxmlformats.org/officeDocument/2006/relationships/image" Target="../media/image6.png"/><Relationship Id="rId5" Type="http://schemas.openxmlformats.org/officeDocument/2006/relationships/chart" Target="../charts/chart4.xml"/><Relationship Id="rId10" Type="http://schemas.openxmlformats.org/officeDocument/2006/relationships/image" Target="../media/image5.png"/><Relationship Id="rId4" Type="http://schemas.openxmlformats.org/officeDocument/2006/relationships/chart" Target="../charts/chart3.xml"/><Relationship Id="rId9" Type="http://schemas.openxmlformats.org/officeDocument/2006/relationships/image" Target="../media/image4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13" Type="http://schemas.openxmlformats.org/officeDocument/2006/relationships/image" Target="../media/image19.png"/><Relationship Id="rId18" Type="http://schemas.openxmlformats.org/officeDocument/2006/relationships/image" Target="../media/image24.jpeg"/><Relationship Id="rId3" Type="http://schemas.openxmlformats.org/officeDocument/2006/relationships/image" Target="../media/image9.png"/><Relationship Id="rId21" Type="http://schemas.openxmlformats.org/officeDocument/2006/relationships/image" Target="../media/image27.png"/><Relationship Id="rId7" Type="http://schemas.openxmlformats.org/officeDocument/2006/relationships/image" Target="../media/image13.png"/><Relationship Id="rId12" Type="http://schemas.openxmlformats.org/officeDocument/2006/relationships/image" Target="../media/image18.png"/><Relationship Id="rId17" Type="http://schemas.openxmlformats.org/officeDocument/2006/relationships/image" Target="../media/image23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22.jpeg"/><Relationship Id="rId20" Type="http://schemas.openxmlformats.org/officeDocument/2006/relationships/image" Target="../media/image26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11" Type="http://schemas.openxmlformats.org/officeDocument/2006/relationships/image" Target="../media/image17.png"/><Relationship Id="rId5" Type="http://schemas.openxmlformats.org/officeDocument/2006/relationships/image" Target="../media/image11.png"/><Relationship Id="rId15" Type="http://schemas.openxmlformats.org/officeDocument/2006/relationships/image" Target="../media/image21.jpeg"/><Relationship Id="rId23" Type="http://schemas.openxmlformats.org/officeDocument/2006/relationships/image" Target="../media/image29.png"/><Relationship Id="rId10" Type="http://schemas.openxmlformats.org/officeDocument/2006/relationships/image" Target="../media/image16.png"/><Relationship Id="rId19" Type="http://schemas.openxmlformats.org/officeDocument/2006/relationships/image" Target="../media/image25.jpeg"/><Relationship Id="rId4" Type="http://schemas.openxmlformats.org/officeDocument/2006/relationships/image" Target="../media/image10.png"/><Relationship Id="rId9" Type="http://schemas.openxmlformats.org/officeDocument/2006/relationships/image" Target="../media/image15.png"/><Relationship Id="rId14" Type="http://schemas.openxmlformats.org/officeDocument/2006/relationships/image" Target="../media/image20.png"/><Relationship Id="rId22" Type="http://schemas.openxmlformats.org/officeDocument/2006/relationships/image" Target="../media/image2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4.png"/><Relationship Id="rId5" Type="http://schemas.openxmlformats.org/officeDocument/2006/relationships/image" Target="../media/image33.png"/><Relationship Id="rId4" Type="http://schemas.openxmlformats.org/officeDocument/2006/relationships/image" Target="../media/image3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35.emf"/><Relationship Id="rId4" Type="http://schemas.openxmlformats.org/officeDocument/2006/relationships/oleObject" Target="../embeddings/oleObject1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37.e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3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990600" y="4980801"/>
            <a:ext cx="7239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JS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889063" y="6553200"/>
            <a:ext cx="10159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D033299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91210241"/>
              </p:ext>
            </p:extLst>
          </p:nvPr>
        </p:nvGraphicFramePr>
        <p:xfrm>
          <a:off x="50577" y="4918410"/>
          <a:ext cx="3302222" cy="1752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1486712" y="4698045"/>
            <a:ext cx="1942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2h treatment both drug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6200000">
            <a:off x="2607305" y="5335611"/>
            <a:ext cx="12954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utli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28917780"/>
              </p:ext>
            </p:extLst>
          </p:nvPr>
        </p:nvGraphicFramePr>
        <p:xfrm>
          <a:off x="3429000" y="4912652"/>
          <a:ext cx="3300984" cy="17556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4" name="TextBox 13"/>
          <p:cNvSpPr txBox="1"/>
          <p:nvPr/>
        </p:nvSpPr>
        <p:spPr>
          <a:xfrm>
            <a:off x="4419600" y="4975044"/>
            <a:ext cx="1447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RL304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343400" y="6581001"/>
            <a:ext cx="12954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D0332991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 rot="16200000">
            <a:off x="6003295" y="5317496"/>
            <a:ext cx="12954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utli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7" name="Chart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85458699"/>
              </p:ext>
            </p:extLst>
          </p:nvPr>
        </p:nvGraphicFramePr>
        <p:xfrm>
          <a:off x="76200" y="7075173"/>
          <a:ext cx="3300984" cy="17556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8" name="TextBox 17"/>
          <p:cNvSpPr txBox="1"/>
          <p:nvPr/>
        </p:nvSpPr>
        <p:spPr>
          <a:xfrm>
            <a:off x="952500" y="6952356"/>
            <a:ext cx="9397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RL3044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914400" y="8790801"/>
            <a:ext cx="10159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D0332991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 rot="16200000">
            <a:off x="2697407" y="7502382"/>
            <a:ext cx="12954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utli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423778" y="6949381"/>
            <a:ext cx="1447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OT-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2" name="Chart 2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58921722"/>
              </p:ext>
            </p:extLst>
          </p:nvPr>
        </p:nvGraphicFramePr>
        <p:xfrm>
          <a:off x="3505200" y="7069097"/>
          <a:ext cx="3300984" cy="17556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3" name="TextBox 22"/>
          <p:cNvSpPr txBox="1"/>
          <p:nvPr/>
        </p:nvSpPr>
        <p:spPr>
          <a:xfrm>
            <a:off x="4499978" y="8771219"/>
            <a:ext cx="12954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D0332991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 rot="16200000">
            <a:off x="6003295" y="7259880"/>
            <a:ext cx="12954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utli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9" name="Picture 6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5956" y="3516851"/>
            <a:ext cx="2482333" cy="32148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90" name="TextBox 89"/>
          <p:cNvSpPr txBox="1"/>
          <p:nvPr/>
        </p:nvSpPr>
        <p:spPr>
          <a:xfrm>
            <a:off x="304800" y="3512578"/>
            <a:ext cx="8382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53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1" name="Picture 90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5955" y="3929001"/>
            <a:ext cx="2482334" cy="37001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92" name="TextBox 91"/>
          <p:cNvSpPr txBox="1"/>
          <p:nvPr/>
        </p:nvSpPr>
        <p:spPr>
          <a:xfrm>
            <a:off x="294442" y="4019618"/>
            <a:ext cx="5437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3" name="Picture 8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8558" y="4389675"/>
            <a:ext cx="2489731" cy="25852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94" name="TextBox 93"/>
          <p:cNvSpPr txBox="1"/>
          <p:nvPr/>
        </p:nvSpPr>
        <p:spPr>
          <a:xfrm>
            <a:off x="76200" y="4341990"/>
            <a:ext cx="762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5" name="Straight Connector 94"/>
          <p:cNvCxnSpPr/>
          <p:nvPr/>
        </p:nvCxnSpPr>
        <p:spPr>
          <a:xfrm>
            <a:off x="861134" y="2344393"/>
            <a:ext cx="491238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6" name="TextBox 95"/>
          <p:cNvSpPr txBox="1"/>
          <p:nvPr/>
        </p:nvSpPr>
        <p:spPr>
          <a:xfrm>
            <a:off x="855956" y="2064778"/>
            <a:ext cx="6680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SJSA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 rot="16200000">
            <a:off x="619026" y="2724719"/>
            <a:ext cx="7002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 rot="16200000">
            <a:off x="626694" y="2519310"/>
            <a:ext cx="11110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utlin 5µM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 rot="16200000">
            <a:off x="867972" y="2534220"/>
            <a:ext cx="10812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utlin 10µM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0" name="Picture 2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9678" y="3175825"/>
            <a:ext cx="2488611" cy="2153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101" name="TextBox 100"/>
          <p:cNvSpPr txBox="1"/>
          <p:nvPr/>
        </p:nvSpPr>
        <p:spPr>
          <a:xfrm>
            <a:off x="228600" y="3131578"/>
            <a:ext cx="6909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dm2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2448131" y="1752600"/>
            <a:ext cx="17428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reatment 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3" name="Picture 2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47067" y="3426761"/>
            <a:ext cx="2487168" cy="41398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104" name="TextBox 103"/>
          <p:cNvSpPr txBox="1"/>
          <p:nvPr/>
        </p:nvSpPr>
        <p:spPr>
          <a:xfrm>
            <a:off x="3513338" y="3429681"/>
            <a:ext cx="83006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pRb 807/811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5" name="Picture 3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47068" y="4314702"/>
            <a:ext cx="2487167" cy="26404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106" name="TextBox 105"/>
          <p:cNvSpPr txBox="1"/>
          <p:nvPr/>
        </p:nvSpPr>
        <p:spPr>
          <a:xfrm>
            <a:off x="3442900" y="4317768"/>
            <a:ext cx="6822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7" name="Straight Connector 106"/>
          <p:cNvCxnSpPr/>
          <p:nvPr/>
        </p:nvCxnSpPr>
        <p:spPr>
          <a:xfrm>
            <a:off x="4156785" y="2260368"/>
            <a:ext cx="523682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8" name="TextBox 107"/>
          <p:cNvSpPr txBox="1"/>
          <p:nvPr/>
        </p:nvSpPr>
        <p:spPr>
          <a:xfrm>
            <a:off x="4147067" y="1995875"/>
            <a:ext cx="6680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SJSA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/>
          <p:cNvSpPr txBox="1"/>
          <p:nvPr/>
        </p:nvSpPr>
        <p:spPr>
          <a:xfrm rot="16200000">
            <a:off x="3910138" y="2970849"/>
            <a:ext cx="7002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 rot="16200000">
            <a:off x="3874016" y="2756149"/>
            <a:ext cx="112962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D0332991 5µM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 rot="16200000">
            <a:off x="4013632" y="2667165"/>
            <a:ext cx="13075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D0332991 10M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2" name="Picture 2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47068" y="3933702"/>
            <a:ext cx="2487167" cy="29266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113" name="TextBox 112"/>
          <p:cNvSpPr txBox="1"/>
          <p:nvPr/>
        </p:nvSpPr>
        <p:spPr>
          <a:xfrm>
            <a:off x="3657600" y="3936768"/>
            <a:ext cx="5459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 rot="16200000">
            <a:off x="1230860" y="2710294"/>
            <a:ext cx="7002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 rot="16200000">
            <a:off x="1234061" y="2504885"/>
            <a:ext cx="11110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utlin 5µM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 rot="16200000">
            <a:off x="1423595" y="2519795"/>
            <a:ext cx="10812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utlin 10µM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 rot="16200000">
            <a:off x="1835993" y="2710294"/>
            <a:ext cx="7002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 rot="16200000">
            <a:off x="1822201" y="2504885"/>
            <a:ext cx="11110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utlin 5µM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 rot="16200000">
            <a:off x="2028728" y="2519795"/>
            <a:ext cx="10812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utlin 10µM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 rot="16200000">
            <a:off x="2432303" y="2710294"/>
            <a:ext cx="7002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 rot="16200000">
            <a:off x="2434481" y="2504886"/>
            <a:ext cx="11110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utlin 5µM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 rot="16200000">
            <a:off x="2638328" y="2519795"/>
            <a:ext cx="10812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utlin 10µM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3" name="Straight Connector 122"/>
          <p:cNvCxnSpPr/>
          <p:nvPr/>
        </p:nvCxnSpPr>
        <p:spPr>
          <a:xfrm>
            <a:off x="1524000" y="2344393"/>
            <a:ext cx="493776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4" name="TextBox 123"/>
          <p:cNvSpPr txBox="1"/>
          <p:nvPr/>
        </p:nvSpPr>
        <p:spPr>
          <a:xfrm>
            <a:off x="1395445" y="2064778"/>
            <a:ext cx="8321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CRL3043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5" name="Straight Connector 124"/>
          <p:cNvCxnSpPr/>
          <p:nvPr/>
        </p:nvCxnSpPr>
        <p:spPr>
          <a:xfrm>
            <a:off x="2119089" y="2344393"/>
            <a:ext cx="49404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6" name="TextBox 125"/>
          <p:cNvSpPr txBox="1"/>
          <p:nvPr/>
        </p:nvSpPr>
        <p:spPr>
          <a:xfrm>
            <a:off x="2035940" y="2064778"/>
            <a:ext cx="9536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CRL3044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7" name="Straight Connector 126"/>
          <p:cNvCxnSpPr/>
          <p:nvPr/>
        </p:nvCxnSpPr>
        <p:spPr>
          <a:xfrm>
            <a:off x="2743200" y="2344393"/>
            <a:ext cx="493776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8" name="TextBox 127"/>
          <p:cNvSpPr txBox="1"/>
          <p:nvPr/>
        </p:nvSpPr>
        <p:spPr>
          <a:xfrm>
            <a:off x="2684756" y="2064778"/>
            <a:ext cx="6680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GOT-3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 rot="16200000">
            <a:off x="4517506" y="2970849"/>
            <a:ext cx="7002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 rot="16200000">
            <a:off x="4483615" y="2756150"/>
            <a:ext cx="112962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D0332991 5µM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 rot="16200000">
            <a:off x="4623231" y="2667166"/>
            <a:ext cx="13075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D0332991 10M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 rot="16200000">
            <a:off x="5127106" y="2970849"/>
            <a:ext cx="7002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 rot="16200000">
            <a:off x="5095448" y="2756150"/>
            <a:ext cx="112962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D0332991 5µM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 rot="16200000">
            <a:off x="5232832" y="2667166"/>
            <a:ext cx="13075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D0332991 10M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 rot="16200000">
            <a:off x="5741171" y="2970849"/>
            <a:ext cx="7002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 rot="16200000">
            <a:off x="5702816" y="2756150"/>
            <a:ext cx="112962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D0332991 5µM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Box 136"/>
          <p:cNvSpPr txBox="1"/>
          <p:nvPr/>
        </p:nvSpPr>
        <p:spPr>
          <a:xfrm rot="16200000">
            <a:off x="5842432" y="2667166"/>
            <a:ext cx="13075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D0332991 10M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8" name="Straight Connector 137"/>
          <p:cNvCxnSpPr/>
          <p:nvPr/>
        </p:nvCxnSpPr>
        <p:spPr>
          <a:xfrm>
            <a:off x="4859044" y="2260368"/>
            <a:ext cx="521208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39" name="TextBox 138"/>
          <p:cNvSpPr txBox="1"/>
          <p:nvPr/>
        </p:nvSpPr>
        <p:spPr>
          <a:xfrm>
            <a:off x="4733364" y="1999722"/>
            <a:ext cx="80414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CRL3043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0" name="Straight Connector 139"/>
          <p:cNvCxnSpPr/>
          <p:nvPr/>
        </p:nvCxnSpPr>
        <p:spPr>
          <a:xfrm>
            <a:off x="5467022" y="2260368"/>
            <a:ext cx="521208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1" name="TextBox 140"/>
          <p:cNvSpPr txBox="1"/>
          <p:nvPr/>
        </p:nvSpPr>
        <p:spPr>
          <a:xfrm>
            <a:off x="5389030" y="1999722"/>
            <a:ext cx="85291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CRL3044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2" name="Straight Connector 141"/>
          <p:cNvCxnSpPr/>
          <p:nvPr/>
        </p:nvCxnSpPr>
        <p:spPr>
          <a:xfrm>
            <a:off x="6053943" y="2260368"/>
            <a:ext cx="521208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3" name="TextBox 142"/>
          <p:cNvSpPr txBox="1"/>
          <p:nvPr/>
        </p:nvSpPr>
        <p:spPr>
          <a:xfrm>
            <a:off x="6037556" y="1995875"/>
            <a:ext cx="6680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GOT-3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0" y="0"/>
            <a:ext cx="1143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31214" y="1817611"/>
            <a:ext cx="1143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31214" y="4642017"/>
            <a:ext cx="1143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3581400" y="1817611"/>
            <a:ext cx="1143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3581400" y="4642017"/>
            <a:ext cx="1143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de-DE" sz="1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31214" y="6796215"/>
            <a:ext cx="1143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3505200" y="6806154"/>
            <a:ext cx="1143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3" name="Picture 5"/>
          <p:cNvPicPr>
            <a:picLocks noChangeAspect="1"/>
          </p:cNvPicPr>
          <p:nvPr/>
        </p:nvPicPr>
        <p:blipFill rotWithShape="1">
          <a:blip r:embed="rId13"/>
          <a:srcRect l="14445" t="30444" r="15555" b="39334"/>
          <a:stretch/>
        </p:blipFill>
        <p:spPr>
          <a:xfrm>
            <a:off x="1143000" y="152400"/>
            <a:ext cx="5562989" cy="1501124"/>
          </a:xfrm>
          <a:prstGeom prst="rect">
            <a:avLst/>
          </a:prstGeom>
        </p:spPr>
      </p:pic>
      <p:sp>
        <p:nvSpPr>
          <p:cNvPr id="2" name="Rechteck 1"/>
          <p:cNvSpPr/>
          <p:nvPr/>
        </p:nvSpPr>
        <p:spPr>
          <a:xfrm>
            <a:off x="2102947" y="592925"/>
            <a:ext cx="92683" cy="381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feld 2"/>
          <p:cNvSpPr txBox="1"/>
          <p:nvPr/>
        </p:nvSpPr>
        <p:spPr>
          <a:xfrm>
            <a:off x="451439" y="789259"/>
            <a:ext cx="615361" cy="369332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de-DE" b="1" dirty="0" smtClean="0"/>
              <a:t>SJSA</a:t>
            </a:r>
            <a:endParaRPr lang="en-US" b="1" dirty="0"/>
          </a:p>
        </p:txBody>
      </p:sp>
      <p:cxnSp>
        <p:nvCxnSpPr>
          <p:cNvPr id="5" name="Gerade Verbindung 4"/>
          <p:cNvCxnSpPr>
            <a:stCxn id="2" idx="2"/>
          </p:cNvCxnSpPr>
          <p:nvPr/>
        </p:nvCxnSpPr>
        <p:spPr>
          <a:xfrm flipH="1">
            <a:off x="1066800" y="973925"/>
            <a:ext cx="108248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Box 76"/>
          <p:cNvSpPr txBox="1"/>
          <p:nvPr/>
        </p:nvSpPr>
        <p:spPr>
          <a:xfrm>
            <a:off x="31214" y="319215"/>
            <a:ext cx="1143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45"/>
          <p:cNvSpPr txBox="1"/>
          <p:nvPr/>
        </p:nvSpPr>
        <p:spPr>
          <a:xfrm>
            <a:off x="6551919" y="3491569"/>
            <a:ext cx="7160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13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TextBox 45"/>
          <p:cNvSpPr txBox="1"/>
          <p:nvPr/>
        </p:nvSpPr>
        <p:spPr>
          <a:xfrm>
            <a:off x="6551919" y="3932307"/>
            <a:ext cx="7160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13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TextBox 45"/>
          <p:cNvSpPr txBox="1"/>
          <p:nvPr/>
        </p:nvSpPr>
        <p:spPr>
          <a:xfrm>
            <a:off x="6563461" y="4359426"/>
            <a:ext cx="7160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45"/>
          <p:cNvSpPr txBox="1"/>
          <p:nvPr/>
        </p:nvSpPr>
        <p:spPr>
          <a:xfrm>
            <a:off x="3261925" y="3139553"/>
            <a:ext cx="7160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Box 45"/>
          <p:cNvSpPr txBox="1"/>
          <p:nvPr/>
        </p:nvSpPr>
        <p:spPr>
          <a:xfrm>
            <a:off x="3261925" y="3546950"/>
            <a:ext cx="7160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Box 45"/>
          <p:cNvSpPr txBox="1"/>
          <p:nvPr/>
        </p:nvSpPr>
        <p:spPr>
          <a:xfrm>
            <a:off x="3271367" y="3892208"/>
            <a:ext cx="7160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45"/>
          <p:cNvSpPr txBox="1"/>
          <p:nvPr/>
        </p:nvSpPr>
        <p:spPr>
          <a:xfrm>
            <a:off x="3271367" y="4368733"/>
            <a:ext cx="7160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65538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9569" y="4596596"/>
            <a:ext cx="1600200" cy="29133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9569" y="3719973"/>
            <a:ext cx="1600200" cy="28212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6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9569" y="2750434"/>
            <a:ext cx="1600200" cy="44878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7" name="Picture 5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9569" y="4148093"/>
            <a:ext cx="1600200" cy="28485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8" name="Picture 6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9569" y="3278271"/>
            <a:ext cx="1600200" cy="32807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9" name="Picture 7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9569" y="2362200"/>
            <a:ext cx="1600200" cy="31472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2591910" y="399365"/>
            <a:ext cx="838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RL304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16200000">
            <a:off x="1879170" y="1847620"/>
            <a:ext cx="8382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6200000">
            <a:off x="1942138" y="1657120"/>
            <a:ext cx="12192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utlin 2.5µM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6200000">
            <a:off x="2195606" y="1657120"/>
            <a:ext cx="12192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utlin 20µM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16200000">
            <a:off x="2449073" y="1657120"/>
            <a:ext cx="12192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D0332991 10µM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 rot="16200000">
            <a:off x="2583500" y="1486747"/>
            <a:ext cx="14522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D0332991 10µM+</a:t>
            </a:r>
          </a:p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utlin 2.5µM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 rot="16200000">
            <a:off x="2877540" y="1486747"/>
            <a:ext cx="14522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D0332991 10µM+</a:t>
            </a:r>
          </a:p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utlin 20µM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959272" y="399365"/>
            <a:ext cx="838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RL3044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Picture 8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95893" y="4596597"/>
            <a:ext cx="1600200" cy="29132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20" name="Picture 9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167" r="4167" b="-5655"/>
          <a:stretch/>
        </p:blipFill>
        <p:spPr bwMode="auto">
          <a:xfrm>
            <a:off x="4495893" y="3719973"/>
            <a:ext cx="1600200" cy="28212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21" name="Picture 10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95893" y="2743200"/>
            <a:ext cx="1600200" cy="45601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22" name="Picture 11"/>
          <p:cNvPicPr>
            <a:picLocks noChangeAspect="1" noChangeArrowheads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30" r="-5292" b="753"/>
          <a:stretch/>
        </p:blipFill>
        <p:spPr bwMode="auto">
          <a:xfrm>
            <a:off x="4495893" y="4148094"/>
            <a:ext cx="1600200" cy="28485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23" name="Picture 12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95893" y="3276600"/>
            <a:ext cx="1600200" cy="32974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24" name="Picture 13"/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95893" y="2354336"/>
            <a:ext cx="1600200" cy="32258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25" name="TextBox 24"/>
          <p:cNvSpPr txBox="1"/>
          <p:nvPr/>
        </p:nvSpPr>
        <p:spPr>
          <a:xfrm rot="16200000">
            <a:off x="4217772" y="1847620"/>
            <a:ext cx="8382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6200000">
            <a:off x="4275285" y="1657120"/>
            <a:ext cx="12192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utlin 2.5µM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 rot="16200000">
            <a:off x="4523298" y="1657120"/>
            <a:ext cx="12192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utlin 20µM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 rot="16200000">
            <a:off x="4771311" y="1657120"/>
            <a:ext cx="12192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D0332991 10µM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 rot="16200000">
            <a:off x="4941233" y="1486747"/>
            <a:ext cx="14522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D0332991 10µM+</a:t>
            </a:r>
          </a:p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utlin 2.5µM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 rot="16200000">
            <a:off x="5246033" y="1486747"/>
            <a:ext cx="14522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D0332991 10µM+</a:t>
            </a:r>
          </a:p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utlin 20µM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1421489" y="4596943"/>
            <a:ext cx="838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1421489" y="2833218"/>
            <a:ext cx="838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m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1421489" y="4128618"/>
            <a:ext cx="838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1421489" y="3329344"/>
            <a:ext cx="838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1421489" y="2376018"/>
            <a:ext cx="838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1421489" y="3747618"/>
            <a:ext cx="838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DK4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0" y="0"/>
            <a:ext cx="1143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-613" y="399365"/>
            <a:ext cx="1143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3810000" y="4583125"/>
            <a:ext cx="838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3810000" y="2819400"/>
            <a:ext cx="838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m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3810000" y="4114800"/>
            <a:ext cx="838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3810000" y="3315526"/>
            <a:ext cx="838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3810000" y="2362200"/>
            <a:ext cx="838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3810000" y="3733800"/>
            <a:ext cx="838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DK4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778024" y="769620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21, l.e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778024" y="7162800"/>
            <a:ext cx="1584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21,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.e.</a:t>
            </a:r>
            <a:endParaRPr 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762000" y="6761801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778024" y="6400800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dm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762000" y="8166037"/>
            <a:ext cx="15841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DK4</a:t>
            </a:r>
            <a:endParaRPr 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5" name="Picture 2" descr="G:\Messrechner\Westerns\Antje\01_Januar2018\24Jan2018__179&amp; 181&amp; for Anusha_actin\24Jan2018__179&amp; 181&amp; for Anusha_actin-5b rotate.jpg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79" t="32490" r="28679" b="61451"/>
          <a:stretch/>
        </p:blipFill>
        <p:spPr bwMode="auto">
          <a:xfrm>
            <a:off x="1507813" y="8561821"/>
            <a:ext cx="1887155" cy="275211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6" name="Picture 7" descr="G:\Personen\Antje Dickmanns\01_Laborbuch\04_Messies Antje\Westerns_Intas\Gele 2018\01_Januar2018\24Jan2018__for Anusha_F\24Jan2018__for Anusha_F-6_rotate2.jp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229" t="36885" r="32787" b="54918"/>
          <a:stretch>
            <a:fillRect/>
          </a:stretch>
        </p:blipFill>
        <p:spPr bwMode="auto">
          <a:xfrm>
            <a:off x="1507813" y="7624486"/>
            <a:ext cx="1877431" cy="375486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7" name="Picture 7" descr="G:\Personen\Antje Dickmanns\01_Laborbuch\04_Messies Antje\Westerns_Intas\Gele 2018\01_Januar2018\24Jan2018__for Anusha_F\24Jan2018__for Anusha_F-6_rotate2.jpg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954" t="25314" r="32883" b="67309"/>
          <a:stretch>
            <a:fillRect/>
          </a:stretch>
        </p:blipFill>
        <p:spPr bwMode="auto">
          <a:xfrm>
            <a:off x="1507813" y="8114310"/>
            <a:ext cx="1872293" cy="34389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8" name="Picture 7" descr="G:\Personen\Antje Dickmanns\01_Laborbuch\04_Messies Antje\Westerns_Intas\Gele 2018\01_Januar2018\24Jan2018__for Anusha_F\24Jan2018__for Anusha_F-6_rotate2.jpg"/>
          <p:cNvPicPr>
            <a:picLocks noChangeAspect="1" noChangeArrowheads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651" t="17464" r="31767" b="76420"/>
          <a:stretch/>
        </p:blipFill>
        <p:spPr bwMode="auto">
          <a:xfrm>
            <a:off x="1507813" y="6361242"/>
            <a:ext cx="1872293" cy="289292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9" name="Picture 2" descr="G:\Messrechner\Westerns\Antje\01_Januar2018\24Jan2018__for Anusha_D\24Jan2018__for Anusha_D-6rotate.jpg"/>
          <p:cNvPicPr>
            <a:picLocks noChangeAspect="1" noChangeArrowheads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852" t="42040" r="32413" b="49549"/>
          <a:stretch/>
        </p:blipFill>
        <p:spPr bwMode="auto">
          <a:xfrm>
            <a:off x="1502675" y="7174390"/>
            <a:ext cx="1882568" cy="37055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1" name="Picture 3" descr="C:\Users\adickma1\Desktop\24Jan2018__for Anusha_p53-7b.jpg"/>
          <p:cNvPicPr>
            <a:picLocks noChangeAspect="1" noChangeArrowheads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717" t="32196" r="27705" b="60383"/>
          <a:stretch/>
        </p:blipFill>
        <p:spPr bwMode="auto">
          <a:xfrm>
            <a:off x="1507813" y="6752503"/>
            <a:ext cx="1872293" cy="34234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3" name="TextBox 132"/>
          <p:cNvSpPr txBox="1"/>
          <p:nvPr/>
        </p:nvSpPr>
        <p:spPr>
          <a:xfrm rot="16200000">
            <a:off x="1138580" y="5744135"/>
            <a:ext cx="10511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 rot="16200000">
            <a:off x="998809" y="5369586"/>
            <a:ext cx="18002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 µM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G7388 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 rot="16200000">
            <a:off x="1468365" y="5369586"/>
            <a:ext cx="18002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 µM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LEE011 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 rot="16200000">
            <a:off x="2453943" y="5629462"/>
            <a:ext cx="12035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 µM 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LEE011 + </a:t>
            </a:r>
          </a:p>
          <a:p>
            <a:pPr lvl="0"/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µM 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RG7388</a:t>
            </a:r>
            <a:endParaRPr lang="de-D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Box 136"/>
          <p:cNvSpPr txBox="1"/>
          <p:nvPr/>
        </p:nvSpPr>
        <p:spPr>
          <a:xfrm rot="16200000">
            <a:off x="1964108" y="5630550"/>
            <a:ext cx="12782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 µM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LY2835219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 rot="16200000">
            <a:off x="2646634" y="5584370"/>
            <a:ext cx="12936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 µM 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LY2835219 +</a:t>
            </a:r>
          </a:p>
          <a:p>
            <a:pPr lvl="0"/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µM 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RG7388</a:t>
            </a:r>
            <a:endParaRPr lang="de-D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 rot="16200000">
            <a:off x="1486844" y="5622843"/>
            <a:ext cx="12936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 µM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D0332991 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 rot="16200000">
            <a:off x="2178775" y="5592077"/>
            <a:ext cx="1278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 µM 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PD0332991 + </a:t>
            </a:r>
          </a:p>
          <a:p>
            <a:pPr lvl="0"/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µM 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RG7388</a:t>
            </a:r>
            <a:endParaRPr lang="de-D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-7768" y="5334000"/>
            <a:ext cx="1143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289278" y="5385063"/>
            <a:ext cx="110093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JSA</a:t>
            </a:r>
          </a:p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h treatment both drug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5" name="Picture 4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54247" y="6907031"/>
            <a:ext cx="1744586" cy="29426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6" name="Picture 5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54248" y="7334772"/>
            <a:ext cx="1744586" cy="29502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7" name="Picture 6"/>
          <p:cNvPicPr>
            <a:picLocks noChangeAspect="1"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54247" y="7765404"/>
            <a:ext cx="1746553" cy="31179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8" name="TextBox 147"/>
          <p:cNvSpPr txBox="1"/>
          <p:nvPr/>
        </p:nvSpPr>
        <p:spPr>
          <a:xfrm>
            <a:off x="3522662" y="6918555"/>
            <a:ext cx="23762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b (807/811) 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3918431" y="7332565"/>
            <a:ext cx="6954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DK4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 rot="16200000">
            <a:off x="3877307" y="5891515"/>
            <a:ext cx="18002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 rot="16200000">
            <a:off x="4128309" y="5891515"/>
            <a:ext cx="18002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LEE011 5µM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152"/>
          <p:cNvSpPr txBox="1"/>
          <p:nvPr/>
        </p:nvSpPr>
        <p:spPr>
          <a:xfrm rot="16200000">
            <a:off x="4379311" y="5891515"/>
            <a:ext cx="18002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LEE011 10µM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 rot="16200000">
            <a:off x="4630313" y="5891515"/>
            <a:ext cx="18002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LY2835219 5µM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Box 154"/>
          <p:cNvSpPr txBox="1"/>
          <p:nvPr/>
        </p:nvSpPr>
        <p:spPr>
          <a:xfrm rot="16200000">
            <a:off x="4881315" y="5891515"/>
            <a:ext cx="18002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LY2835219 10µM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TextBox 155"/>
          <p:cNvSpPr txBox="1"/>
          <p:nvPr/>
        </p:nvSpPr>
        <p:spPr>
          <a:xfrm rot="16200000">
            <a:off x="5132317" y="5891515"/>
            <a:ext cx="18002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D0332991 5µM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TextBox 156"/>
          <p:cNvSpPr txBox="1"/>
          <p:nvPr/>
        </p:nvSpPr>
        <p:spPr>
          <a:xfrm rot="16200000">
            <a:off x="5383317" y="5891515"/>
            <a:ext cx="18002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D0332991 10µM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3937657" y="5375124"/>
            <a:ext cx="201622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JSA </a:t>
            </a:r>
          </a:p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4h treatment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TextBox 158"/>
          <p:cNvSpPr txBox="1"/>
          <p:nvPr/>
        </p:nvSpPr>
        <p:spPr>
          <a:xfrm>
            <a:off x="3903662" y="7765404"/>
            <a:ext cx="838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Box 159"/>
          <p:cNvSpPr txBox="1"/>
          <p:nvPr/>
        </p:nvSpPr>
        <p:spPr>
          <a:xfrm>
            <a:off x="750972" y="8560279"/>
            <a:ext cx="838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3656452" y="5334000"/>
            <a:ext cx="1143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4" name="Straight Connector 93"/>
          <p:cNvCxnSpPr/>
          <p:nvPr/>
        </p:nvCxnSpPr>
        <p:spPr>
          <a:xfrm>
            <a:off x="315742" y="914400"/>
            <a:ext cx="93709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5" name="TextBox 94"/>
          <p:cNvSpPr txBox="1"/>
          <p:nvPr/>
        </p:nvSpPr>
        <p:spPr>
          <a:xfrm>
            <a:off x="352727" y="1428690"/>
            <a:ext cx="12954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D0332991 </a:t>
            </a:r>
          </a:p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µM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414634" y="637401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7" name="Straight Connector 96"/>
          <p:cNvCxnSpPr/>
          <p:nvPr/>
        </p:nvCxnSpPr>
        <p:spPr>
          <a:xfrm>
            <a:off x="948034" y="822169"/>
            <a:ext cx="0" cy="2286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8" name="TextBox 97"/>
          <p:cNvSpPr txBox="1"/>
          <p:nvPr/>
        </p:nvSpPr>
        <p:spPr>
          <a:xfrm>
            <a:off x="762000" y="1125379"/>
            <a:ext cx="1295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utlin 2.5/20µM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9" name="Straight Connector 98"/>
          <p:cNvCxnSpPr/>
          <p:nvPr/>
        </p:nvCxnSpPr>
        <p:spPr>
          <a:xfrm>
            <a:off x="304800" y="1428690"/>
            <a:ext cx="94507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0" name="Straight Connector 99"/>
          <p:cNvCxnSpPr/>
          <p:nvPr/>
        </p:nvCxnSpPr>
        <p:spPr>
          <a:xfrm>
            <a:off x="1252834" y="822169"/>
            <a:ext cx="0" cy="2286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1" name="Straight Connector 100"/>
          <p:cNvCxnSpPr/>
          <p:nvPr/>
        </p:nvCxnSpPr>
        <p:spPr>
          <a:xfrm>
            <a:off x="948034" y="1100152"/>
            <a:ext cx="3048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2" name="TextBox 101"/>
          <p:cNvSpPr txBox="1"/>
          <p:nvPr/>
        </p:nvSpPr>
        <p:spPr>
          <a:xfrm>
            <a:off x="962327" y="637401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1752600" y="399365"/>
            <a:ext cx="1143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4073670" y="399365"/>
            <a:ext cx="1143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45"/>
          <p:cNvSpPr txBox="1"/>
          <p:nvPr/>
        </p:nvSpPr>
        <p:spPr>
          <a:xfrm>
            <a:off x="6042219" y="2358104"/>
            <a:ext cx="7160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13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45"/>
          <p:cNvSpPr txBox="1"/>
          <p:nvPr/>
        </p:nvSpPr>
        <p:spPr>
          <a:xfrm>
            <a:off x="6042219" y="2811596"/>
            <a:ext cx="7160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10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45"/>
          <p:cNvSpPr txBox="1"/>
          <p:nvPr/>
        </p:nvSpPr>
        <p:spPr>
          <a:xfrm>
            <a:off x="6042219" y="3345208"/>
            <a:ext cx="7160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55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45"/>
          <p:cNvSpPr txBox="1"/>
          <p:nvPr/>
        </p:nvSpPr>
        <p:spPr>
          <a:xfrm>
            <a:off x="6042219" y="3689394"/>
            <a:ext cx="7160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35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45"/>
          <p:cNvSpPr txBox="1"/>
          <p:nvPr/>
        </p:nvSpPr>
        <p:spPr>
          <a:xfrm>
            <a:off x="6042219" y="4108671"/>
            <a:ext cx="7160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25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45"/>
          <p:cNvSpPr txBox="1"/>
          <p:nvPr/>
        </p:nvSpPr>
        <p:spPr>
          <a:xfrm>
            <a:off x="6042219" y="4627720"/>
            <a:ext cx="7160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45"/>
          <p:cNvSpPr txBox="1"/>
          <p:nvPr/>
        </p:nvSpPr>
        <p:spPr>
          <a:xfrm>
            <a:off x="3322555" y="6326565"/>
            <a:ext cx="7160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10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45"/>
          <p:cNvSpPr txBox="1"/>
          <p:nvPr/>
        </p:nvSpPr>
        <p:spPr>
          <a:xfrm>
            <a:off x="3322555" y="6860177"/>
            <a:ext cx="7160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55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45"/>
          <p:cNvSpPr txBox="1"/>
          <p:nvPr/>
        </p:nvSpPr>
        <p:spPr>
          <a:xfrm>
            <a:off x="3322555" y="7094448"/>
            <a:ext cx="7160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25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45"/>
          <p:cNvSpPr txBox="1"/>
          <p:nvPr/>
        </p:nvSpPr>
        <p:spPr>
          <a:xfrm>
            <a:off x="3322555" y="7574857"/>
            <a:ext cx="7160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25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45"/>
          <p:cNvSpPr txBox="1"/>
          <p:nvPr/>
        </p:nvSpPr>
        <p:spPr>
          <a:xfrm>
            <a:off x="3322555" y="8591056"/>
            <a:ext cx="7160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45"/>
          <p:cNvSpPr txBox="1"/>
          <p:nvPr/>
        </p:nvSpPr>
        <p:spPr>
          <a:xfrm>
            <a:off x="3322555" y="8090521"/>
            <a:ext cx="7160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35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45"/>
          <p:cNvSpPr txBox="1"/>
          <p:nvPr/>
        </p:nvSpPr>
        <p:spPr>
          <a:xfrm>
            <a:off x="6347077" y="6980110"/>
            <a:ext cx="7160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13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45"/>
          <p:cNvSpPr txBox="1"/>
          <p:nvPr/>
        </p:nvSpPr>
        <p:spPr>
          <a:xfrm>
            <a:off x="6347077" y="7305325"/>
            <a:ext cx="7160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35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45"/>
          <p:cNvSpPr txBox="1"/>
          <p:nvPr/>
        </p:nvSpPr>
        <p:spPr>
          <a:xfrm>
            <a:off x="6347077" y="7792722"/>
            <a:ext cx="7160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262051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 rot="16200000">
            <a:off x="4157191" y="3107313"/>
            <a:ext cx="9144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 rot="16200000">
            <a:off x="4092038" y="2852777"/>
            <a:ext cx="14234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utlin 20µM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 rot="16200000">
            <a:off x="4310931" y="2852777"/>
            <a:ext cx="14234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A-64 5µM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686091" y="4114089"/>
            <a:ext cx="838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686091" y="4590339"/>
            <a:ext cx="838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DK4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686091" y="5066589"/>
            <a:ext cx="838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686091" y="5542839"/>
            <a:ext cx="838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686091" y="3637839"/>
            <a:ext cx="838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dm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98975" y="3646748"/>
            <a:ext cx="1292225" cy="26193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14" name="TextBox 13"/>
          <p:cNvSpPr txBox="1"/>
          <p:nvPr/>
        </p:nvSpPr>
        <p:spPr>
          <a:xfrm rot="16200000">
            <a:off x="4498355" y="2852777"/>
            <a:ext cx="14234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A-64 10µM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 rot="16200000">
            <a:off x="4719995" y="2852777"/>
            <a:ext cx="14234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utlin 20µM + A-64 5µM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 rot="16200000">
            <a:off x="4788320" y="2677049"/>
            <a:ext cx="17749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utlin 20µM + A-64 10µM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98891" y="4159285"/>
            <a:ext cx="1292309" cy="20876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9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7941" y="4618654"/>
            <a:ext cx="1273259" cy="21902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20" name="Picture 6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7941" y="5088278"/>
            <a:ext cx="1273259" cy="20396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21" name="Picture 7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24291" y="5542840"/>
            <a:ext cx="1266909" cy="23508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cxnSp>
        <p:nvCxnSpPr>
          <p:cNvPr id="22" name="Straight Connector 24"/>
          <p:cNvCxnSpPr/>
          <p:nvPr/>
        </p:nvCxnSpPr>
        <p:spPr>
          <a:xfrm flipV="1">
            <a:off x="931176" y="3154142"/>
            <a:ext cx="930306" cy="427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4" name="TextBox 29"/>
          <p:cNvSpPr txBox="1"/>
          <p:nvPr/>
        </p:nvSpPr>
        <p:spPr>
          <a:xfrm>
            <a:off x="908981" y="3616048"/>
            <a:ext cx="1744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-64 5µM/10µM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Straight Connector 30"/>
          <p:cNvCxnSpPr/>
          <p:nvPr/>
        </p:nvCxnSpPr>
        <p:spPr>
          <a:xfrm>
            <a:off x="1574410" y="3060320"/>
            <a:ext cx="0" cy="2286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Straight Connector 31"/>
          <p:cNvCxnSpPr/>
          <p:nvPr/>
        </p:nvCxnSpPr>
        <p:spPr>
          <a:xfrm>
            <a:off x="1861482" y="3060320"/>
            <a:ext cx="0" cy="2286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32"/>
          <p:cNvSpPr txBox="1"/>
          <p:nvPr/>
        </p:nvSpPr>
        <p:spPr>
          <a:xfrm>
            <a:off x="1357647" y="3313488"/>
            <a:ext cx="1295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utlin 20µM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33"/>
          <p:cNvSpPr txBox="1"/>
          <p:nvPr/>
        </p:nvSpPr>
        <p:spPr>
          <a:xfrm>
            <a:off x="1556682" y="2799198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Straight Connector 34"/>
          <p:cNvCxnSpPr/>
          <p:nvPr/>
        </p:nvCxnSpPr>
        <p:spPr>
          <a:xfrm>
            <a:off x="931176" y="3601484"/>
            <a:ext cx="94507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TextBox 35"/>
          <p:cNvSpPr txBox="1"/>
          <p:nvPr/>
        </p:nvSpPr>
        <p:spPr>
          <a:xfrm>
            <a:off x="1905000" y="3031031"/>
            <a:ext cx="1295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arves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6"/>
          <p:cNvSpPr txBox="1"/>
          <p:nvPr/>
        </p:nvSpPr>
        <p:spPr>
          <a:xfrm>
            <a:off x="1041010" y="2795469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45"/>
          <p:cNvSpPr txBox="1"/>
          <p:nvPr/>
        </p:nvSpPr>
        <p:spPr>
          <a:xfrm>
            <a:off x="1194732" y="2267722"/>
            <a:ext cx="9715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SJS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46"/>
          <p:cNvSpPr txBox="1"/>
          <p:nvPr/>
        </p:nvSpPr>
        <p:spPr>
          <a:xfrm>
            <a:off x="786147" y="2236944"/>
            <a:ext cx="1143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47"/>
          <p:cNvSpPr txBox="1"/>
          <p:nvPr/>
        </p:nvSpPr>
        <p:spPr>
          <a:xfrm>
            <a:off x="3657600" y="2236944"/>
            <a:ext cx="1143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84"/>
          <p:cNvSpPr txBox="1"/>
          <p:nvPr/>
        </p:nvSpPr>
        <p:spPr>
          <a:xfrm>
            <a:off x="0" y="0"/>
            <a:ext cx="11430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,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tinued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45"/>
          <p:cNvSpPr txBox="1"/>
          <p:nvPr/>
        </p:nvSpPr>
        <p:spPr>
          <a:xfrm>
            <a:off x="5728975" y="5532738"/>
            <a:ext cx="7160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45"/>
          <p:cNvSpPr txBox="1"/>
          <p:nvPr/>
        </p:nvSpPr>
        <p:spPr>
          <a:xfrm>
            <a:off x="5728975" y="5010871"/>
            <a:ext cx="7160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25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45"/>
          <p:cNvSpPr txBox="1"/>
          <p:nvPr/>
        </p:nvSpPr>
        <p:spPr>
          <a:xfrm>
            <a:off x="5728975" y="4541247"/>
            <a:ext cx="7160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35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5"/>
          <p:cNvSpPr txBox="1"/>
          <p:nvPr/>
        </p:nvSpPr>
        <p:spPr>
          <a:xfrm>
            <a:off x="5728975" y="4174840"/>
            <a:ext cx="7160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55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5"/>
          <p:cNvSpPr txBox="1"/>
          <p:nvPr/>
        </p:nvSpPr>
        <p:spPr>
          <a:xfrm>
            <a:off x="5728975" y="3633752"/>
            <a:ext cx="7160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10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923902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1143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78919590"/>
              </p:ext>
            </p:extLst>
          </p:nvPr>
        </p:nvGraphicFramePr>
        <p:xfrm>
          <a:off x="1524000" y="1371600"/>
          <a:ext cx="4342994" cy="228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5" name="Prism 5" r:id="rId4" imgW="5088600" imgH="2677680" progId="Prism5.Document">
                  <p:embed/>
                </p:oleObj>
              </mc:Choice>
              <mc:Fallback>
                <p:oleObj name="Prism 5" r:id="rId4" imgW="5088600" imgH="267768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524000" y="1371600"/>
                        <a:ext cx="4342994" cy="228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7196472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78172620"/>
              </p:ext>
            </p:extLst>
          </p:nvPr>
        </p:nvGraphicFramePr>
        <p:xfrm>
          <a:off x="2500312" y="1020763"/>
          <a:ext cx="2825496" cy="19228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6" name="Prism 5" r:id="rId3" imgW="3940920" imgH="2682000" progId="Prism5.Document">
                  <p:embed/>
                </p:oleObj>
              </mc:Choice>
              <mc:Fallback>
                <p:oleObj name="Prism 5" r:id="rId3" imgW="3940920" imgH="2682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500312" y="1020763"/>
                        <a:ext cx="2825496" cy="192286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0" y="0"/>
            <a:ext cx="1143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438400" y="1025801"/>
            <a:ext cx="1143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4830948"/>
              </p:ext>
            </p:extLst>
          </p:nvPr>
        </p:nvGraphicFramePr>
        <p:xfrm>
          <a:off x="2495550" y="3168650"/>
          <a:ext cx="2825750" cy="1924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7" name="Prism 5" r:id="rId5" imgW="3940920" imgH="2682000" progId="Prism5.Document">
                  <p:embed/>
                </p:oleObj>
              </mc:Choice>
              <mc:Fallback>
                <p:oleObj name="Prism 5" r:id="rId5" imgW="3940920" imgH="2682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495550" y="3168650"/>
                        <a:ext cx="2825750" cy="19240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332460" y="1025801"/>
            <a:ext cx="1143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Straight Connector 12"/>
          <p:cNvCxnSpPr/>
          <p:nvPr/>
        </p:nvCxnSpPr>
        <p:spPr>
          <a:xfrm>
            <a:off x="648815" y="1676400"/>
            <a:ext cx="93709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685800" y="2190690"/>
            <a:ext cx="12954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D0332991 </a:t>
            </a:r>
          </a:p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µM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747707" y="1399401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Straight Connector 15"/>
          <p:cNvCxnSpPr/>
          <p:nvPr/>
        </p:nvCxnSpPr>
        <p:spPr>
          <a:xfrm>
            <a:off x="1281107" y="1584169"/>
            <a:ext cx="0" cy="2286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1095073" y="1887379"/>
            <a:ext cx="1295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utlin 20µM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Straight Connector 17"/>
          <p:cNvCxnSpPr/>
          <p:nvPr/>
        </p:nvCxnSpPr>
        <p:spPr>
          <a:xfrm>
            <a:off x="637873" y="2190690"/>
            <a:ext cx="94507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1281107" y="1862152"/>
            <a:ext cx="3048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1295400" y="1399401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2438400" y="3168650"/>
            <a:ext cx="1143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tangle 21"/>
          <p:cNvSpPr/>
          <p:nvPr/>
        </p:nvSpPr>
        <p:spPr>
          <a:xfrm>
            <a:off x="3200400" y="5562600"/>
            <a:ext cx="381000" cy="164592"/>
          </a:xfrm>
          <a:prstGeom prst="rect">
            <a:avLst/>
          </a:prstGeom>
          <a:solidFill>
            <a:srgbClr val="009900"/>
          </a:solidFill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23" name="TextBox 22"/>
          <p:cNvSpPr txBox="1"/>
          <p:nvPr/>
        </p:nvSpPr>
        <p:spPr>
          <a:xfrm>
            <a:off x="3584864" y="5500232"/>
            <a:ext cx="914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3200400" y="5782732"/>
            <a:ext cx="384048" cy="164592"/>
          </a:xfrm>
          <a:prstGeom prst="rect">
            <a:avLst/>
          </a:prstGeom>
          <a:solidFill>
            <a:srgbClr val="FF33CC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25" name="TextBox 24"/>
          <p:cNvSpPr txBox="1"/>
          <p:nvPr/>
        </p:nvSpPr>
        <p:spPr>
          <a:xfrm>
            <a:off x="3577937" y="5719689"/>
            <a:ext cx="12815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utlin 20µM 6h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3200400" y="6011333"/>
            <a:ext cx="384048" cy="165556"/>
          </a:xfrm>
          <a:prstGeom prst="rect">
            <a:avLst/>
          </a:prstGeom>
          <a:solidFill>
            <a:srgbClr val="FF0000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27" name="TextBox 26"/>
          <p:cNvSpPr txBox="1"/>
          <p:nvPr/>
        </p:nvSpPr>
        <p:spPr>
          <a:xfrm>
            <a:off x="3577937" y="5935133"/>
            <a:ext cx="9144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D0332991 10µM 30h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Rectangle 27"/>
          <p:cNvSpPr/>
          <p:nvPr/>
        </p:nvSpPr>
        <p:spPr>
          <a:xfrm>
            <a:off x="3200400" y="6239932"/>
            <a:ext cx="384048" cy="164592"/>
          </a:xfrm>
          <a:prstGeom prst="rect">
            <a:avLst/>
          </a:prstGeom>
          <a:solidFill>
            <a:srgbClr val="0033CC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29" name="TextBox 28"/>
          <p:cNvSpPr txBox="1"/>
          <p:nvPr/>
        </p:nvSpPr>
        <p:spPr>
          <a:xfrm>
            <a:off x="3577937" y="6175401"/>
            <a:ext cx="12815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utlin 20µM 6h+</a:t>
            </a:r>
          </a:p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D0332991 10µM 30h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Straight Connector 29"/>
          <p:cNvCxnSpPr/>
          <p:nvPr/>
        </p:nvCxnSpPr>
        <p:spPr>
          <a:xfrm>
            <a:off x="1582948" y="1584169"/>
            <a:ext cx="0" cy="2286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TextBox 28"/>
          <p:cNvSpPr txBox="1"/>
          <p:nvPr/>
        </p:nvSpPr>
        <p:spPr>
          <a:xfrm>
            <a:off x="645611" y="996573"/>
            <a:ext cx="160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JS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35671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338</Words>
  <Application>Microsoft Office PowerPoint</Application>
  <PresentationFormat>On-screen Show (4:3)</PresentationFormat>
  <Paragraphs>199</Paragraphs>
  <Slides>5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Larissa</vt:lpstr>
      <vt:lpstr>Prism 5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ätsmedizin Göttinge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obbelstein, Matthias</dc:creator>
  <cp:lastModifiedBy>Sriraman, Anusha</cp:lastModifiedBy>
  <cp:revision>7</cp:revision>
  <dcterms:created xsi:type="dcterms:W3CDTF">2018-04-27T10:33:02Z</dcterms:created>
  <dcterms:modified xsi:type="dcterms:W3CDTF">2018-05-15T11:04:53Z</dcterms:modified>
</cp:coreProperties>
</file>